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318" r:id="rId2"/>
    <p:sldId id="319" r:id="rId3"/>
    <p:sldId id="300" r:id="rId4"/>
    <p:sldId id="325" r:id="rId5"/>
    <p:sldId id="320" r:id="rId6"/>
    <p:sldId id="313" r:id="rId7"/>
    <p:sldId id="265" r:id="rId8"/>
    <p:sldId id="322" r:id="rId9"/>
    <p:sldId id="324" r:id="rId10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hang, Hongji" initials="ZH" lastIdx="2" clrIdx="0">
    <p:extLst>
      <p:ext uri="{19B8F6BF-5375-455C-9EA6-DF929625EA0E}">
        <p15:presenceInfo xmlns:p15="http://schemas.microsoft.com/office/powerpoint/2012/main" userId="Zhang, Hongj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65CF"/>
    <a:srgbClr val="25FB2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416" autoAdjust="0"/>
    <p:restoredTop sz="53563" autoAdjust="0"/>
  </p:normalViewPr>
  <p:slideViewPr>
    <p:cSldViewPr snapToGrid="0" snapToObjects="1">
      <p:cViewPr varScale="1">
        <p:scale>
          <a:sx n="31" d="100"/>
          <a:sy n="31" d="100"/>
        </p:scale>
        <p:origin x="2604" y="5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wmf"/><Relationship Id="rId2" Type="http://schemas.openxmlformats.org/officeDocument/2006/relationships/image" Target="../media/image14.wmf"/><Relationship Id="rId1" Type="http://schemas.openxmlformats.org/officeDocument/2006/relationships/image" Target="../media/image13.wmf"/><Relationship Id="rId5" Type="http://schemas.openxmlformats.org/officeDocument/2006/relationships/image" Target="../media/image17.emf"/><Relationship Id="rId4" Type="http://schemas.openxmlformats.org/officeDocument/2006/relationships/image" Target="../media/image16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7.emf"/><Relationship Id="rId2" Type="http://schemas.openxmlformats.org/officeDocument/2006/relationships/image" Target="../media/image66.emf"/><Relationship Id="rId1" Type="http://schemas.openxmlformats.org/officeDocument/2006/relationships/image" Target="../media/image65.emf"/><Relationship Id="rId4" Type="http://schemas.openxmlformats.org/officeDocument/2006/relationships/image" Target="../media/image6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77.wmf"/><Relationship Id="rId2" Type="http://schemas.openxmlformats.org/officeDocument/2006/relationships/image" Target="../media/image76.wmf"/><Relationship Id="rId1" Type="http://schemas.openxmlformats.org/officeDocument/2006/relationships/image" Target="../media/image75.wmf"/><Relationship Id="rId4" Type="http://schemas.openxmlformats.org/officeDocument/2006/relationships/image" Target="../media/image78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95.wmf"/><Relationship Id="rId3" Type="http://schemas.openxmlformats.org/officeDocument/2006/relationships/image" Target="../media/image90.emf"/><Relationship Id="rId7" Type="http://schemas.openxmlformats.org/officeDocument/2006/relationships/image" Target="../media/image94.wmf"/><Relationship Id="rId2" Type="http://schemas.openxmlformats.org/officeDocument/2006/relationships/image" Target="../media/image89.emf"/><Relationship Id="rId1" Type="http://schemas.openxmlformats.org/officeDocument/2006/relationships/image" Target="../media/image88.emf"/><Relationship Id="rId6" Type="http://schemas.openxmlformats.org/officeDocument/2006/relationships/image" Target="../media/image93.emf"/><Relationship Id="rId5" Type="http://schemas.openxmlformats.org/officeDocument/2006/relationships/image" Target="../media/image92.emf"/><Relationship Id="rId10" Type="http://schemas.openxmlformats.org/officeDocument/2006/relationships/image" Target="../media/image97.emf"/><Relationship Id="rId4" Type="http://schemas.openxmlformats.org/officeDocument/2006/relationships/image" Target="../media/image91.emf"/><Relationship Id="rId9" Type="http://schemas.openxmlformats.org/officeDocument/2006/relationships/image" Target="../media/image9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9C73F8-ADBA-8840-8A2E-40A5693A0BFD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B44314-1ED2-684B-8DF7-03461F31B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649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 of patients with liver resection vs. Non-resection volunteers</a:t>
            </a:r>
          </a:p>
          <a:p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* p values obtained by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alysis of variance and Student t-test (GraphPad Prism version 5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ALT - alanine aminotransferase, AST - aspartate aminotransferase, INR - international normalized ratio.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0446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.1. </a:t>
            </a:r>
            <a:r>
              <a:rPr lang="en-US" altLang="zh-CN" sz="1200" b="1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romboelastography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alysis curve and platelet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gregometry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ram.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0" i="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xamples of </a:t>
            </a:r>
            <a:r>
              <a:rPr lang="en-US" altLang="zh-CN" sz="1200" b="0" i="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romboelastography</a:t>
            </a:r>
            <a:r>
              <a:rPr lang="en-US" altLang="zh-CN" sz="1200" b="0" i="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alysis of (A)human samples from patient</a:t>
            </a:r>
            <a:r>
              <a:rPr lang="en-US" altLang="zh-CN" sz="1200" b="0" i="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undergoing liver resection and normal healthy control; (B)mice </a:t>
            </a:r>
            <a:r>
              <a:rPr lang="en-US" altLang="zh-CN" sz="1200" b="0" i="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ith and without liver I/R; (C)platelet aggregometry analysis</a:t>
            </a:r>
            <a:r>
              <a:rPr lang="en-US" altLang="zh-CN" sz="1200" b="0" i="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f  mice with and without liver I/R. 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887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.2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Gating</a:t>
            </a:r>
            <a:r>
              <a:rPr lang="en-US" altLang="zh-CN" sz="1200" b="1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tegy for flow cytometric characterization.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A)Platelet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ctivation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irculating platelet neutrophil aggregate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d (B)organs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eutrophils infiltration. (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bbreviation:  PL: Platelet; PL-N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latelet-Neutrophil;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VD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Fixable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Viability Dye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)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04466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.3. Liver I/R results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l and remote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vessel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rombi with organ injury. 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e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ith sham mice I/R leads to a (A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significant increase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latelet activation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d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B) increased circulating platelet neutrophil aggregates; (C) serum ALT levels increase, peaked at 6 hours after reperfusion with falling back at 24 hours;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D)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evere sinusoidal dilatation and pericentral hepatocellular necrosis by histologic evaluation; (E) greater accumulation of platelets and presence of microvascular thrombi within the sinusoids, with staining for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D41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green), nuclei (blue), fibrinogen(red), and Actin (white), scale bar, 25 </a:t>
            </a:r>
            <a:r>
              <a:rPr lang="el-GR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μ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; (F) progressively increasing lung injury score and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G)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evere sinusoidal dilatation and pericentral hepatocellular necrosis by histologic evaluation. (n=6-8 each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rou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Abbreviation: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)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00320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.4.</a:t>
            </a:r>
            <a:r>
              <a:rPr lang="da-DK" altLang="zh-CN" sz="1200" b="1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Ts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involved in local and systemic organ injury after hepatic stress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ompare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ith sham mice I/R leads to a</a:t>
            </a:r>
            <a:r>
              <a:rPr lang="da-DK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eutrophil migration into not only the</a:t>
            </a:r>
            <a:r>
              <a:rPr lang="da-DK" altLang="zh-CN" sz="1200" b="0" i="0" u="none" strike="noStrike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iver but also into the lung an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idney;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B) </a:t>
            </a:r>
            <a:r>
              <a:rPr lang="da-DK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ham group for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munofluorescence imaging(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agnification×20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ith staining for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D41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green), nuclei (blue), citrullinated histone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3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it-H3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(red), and Actin (white).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n=6-8 in each group).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cale bar, 25 </a:t>
            </a:r>
            <a:r>
              <a:rPr lang="el-GR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μ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. (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bbreviation: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.)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0065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.5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se treatment prevents neutrophils infiltration and inhibit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T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mation  in the organs after liver I/R.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Nase treatment in the I/R mice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duce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A)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neutrophil recruitment in lung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kidney and liver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y flow cytometry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d (B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NETs formation by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itrullinated-histone-3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otein level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liver, lung and kidne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ere determined by western blot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(n=7-12 in each group)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bbreviation: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ETs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b="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eutrophil Extracellular </a:t>
            </a:r>
            <a:r>
              <a:rPr lang="en-US" altLang="zh-CN" sz="1200" b="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aps,Cit-H3: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itrullinated-Histone-3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)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9694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.6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hibiting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T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cts against  systemic hypercoagulability and microvascular-thrombi mediated organ injury after liver I/R.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mpared with PBS injection mice, b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cking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ETs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rmation in the I/R mice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duced (A) lung injury score; (B) serum creatinine and cystatin C levels; (C)serum ALT levels and (D) accumulation of platelets an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esence of microvascular thrombi within the sinusoids, with staining for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D41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green), nuclei(blue), 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brinogen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red), and Actin (white),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cale bar, 25 </a:t>
            </a:r>
            <a:r>
              <a:rPr lang="el-GR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μ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re is no significant difference between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D4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/- and DNase group,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d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eated </a:t>
            </a:r>
            <a:r>
              <a:rPr lang="en-US" altLang="zh-CN" sz="1200" kern="1200" baseline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AD4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-/- mice with exogenous isolated </a:t>
            </a:r>
            <a:r>
              <a:rPr lang="en-US" altLang="zh-CN" sz="1200" kern="1200" baseline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ET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which was comparable to the effects seen in PBS injection mice with systemic hypercoagulable status, local and distant organ injury of liver, lung and kidney result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n=6-8 each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rou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bbreviation: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.)</a:t>
            </a:r>
            <a:endParaRPr lang="zh-CN" altLang="en-US" sz="1200" b="1" i="1" u="sng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09112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.7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hibiting NETs-platelet interaction by TLR4 depletion in platelets protects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the systemic effects after I/R.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mpared with FLOX mice,TLR4loxP/Pf4-Cre mice undergoing liver IR reduce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duce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A)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ung injury score;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) serum creatinine and cystatin C levels; (C) serum ALT levels and (D) accumulation of platelets and presence of microvascular thrombi within the sinusoids, with staining for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D41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green), nuclei(blue),fibrinogen(red), and Actin (white), scale bar, 25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μm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increased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rgans damage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lox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mice treated with PMA-free isolated NETs whereas no significant difference in PF4 TLR4 KO mice when treated with PMA-free isolated.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E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ETs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rmation by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itrullinated-histone-3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otein level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liver, lung and kidne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ere determined by western blot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n=6-8 each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rou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Abbreviation: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64535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.8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hibiting NETs-platelet interaction by TLR4 depletion in platelets protects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the systemic effects after I/R.</a:t>
            </a:r>
          </a:p>
          <a:p>
            <a:pPr marL="0" marR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ild-type (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X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and mice lacking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LR4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n platelets (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F4-cre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were depleted of their platelets using anti-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D41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tibody and subsequently transfused donor platelets isolated from either their littermates (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XP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ans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X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F4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ans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F4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as controls or from donors with opposite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LR4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atus with respect to their platelets (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XP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ans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F4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F4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ans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X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to test the specific role of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LR4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n platelets in IR. Thromboelastographic are shown (A) time to clot formation by R-time and clot strength by MA; (B)the rate of whole blood aggregation and platelet activation; (C)circulating platelet neutrophil aggregates; (D) liver injury by serum ALT levels; (E)lung injury by histology; (F)kidney injury by serum BUN, creatinine and cystatin C levels. (n=6-8 each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rou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Abbreviation: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6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2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;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h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schemia 1.5 hours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llowed by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4 hours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rfusion; D: Donor; R: Recipient; FLOX: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LR4lox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LOX,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F4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KO: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LR4lox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/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f4-Cre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)</a:t>
            </a:r>
            <a:endParaRPr lang="zh-CN" altLang="en-US" sz="1200" b="1" i="1" u="sng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B44314-1ED2-684B-8DF7-03461F31B9D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804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824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26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575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804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934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724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622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922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005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540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6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0D674A-B5B5-7A41-9B8E-1C9582BFA1B9}" type="datetimeFigureOut">
              <a:rPr lang="en-US" smtClean="0"/>
              <a:t>4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7B8F7-A590-1647-BCF2-912887985A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625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15.wmf"/><Relationship Id="rId3" Type="http://schemas.openxmlformats.org/officeDocument/2006/relationships/notesSlide" Target="../notesSlides/notesSlide4.xml"/><Relationship Id="rId21" Type="http://schemas.openxmlformats.org/officeDocument/2006/relationships/oleObject" Target="../embeddings/oleObject5.bin"/><Relationship Id="rId7" Type="http://schemas.openxmlformats.org/officeDocument/2006/relationships/image" Target="../media/image21.png"/><Relationship Id="rId12" Type="http://schemas.microsoft.com/office/2007/relationships/hdphoto" Target="../media/hdphoto2.wdp"/><Relationship Id="rId17" Type="http://schemas.openxmlformats.org/officeDocument/2006/relationships/oleObject" Target="../embeddings/oleObject3.bin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14.wmf"/><Relationship Id="rId20" Type="http://schemas.openxmlformats.org/officeDocument/2006/relationships/image" Target="../media/image16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0.png"/><Relationship Id="rId11" Type="http://schemas.openxmlformats.org/officeDocument/2006/relationships/image" Target="../media/image24.png"/><Relationship Id="rId5" Type="http://schemas.openxmlformats.org/officeDocument/2006/relationships/image" Target="../media/image19.png"/><Relationship Id="rId15" Type="http://schemas.openxmlformats.org/officeDocument/2006/relationships/oleObject" Target="../embeddings/oleObject2.bin"/><Relationship Id="rId10" Type="http://schemas.microsoft.com/office/2007/relationships/hdphoto" Target="../media/hdphoto1.wdp"/><Relationship Id="rId19" Type="http://schemas.openxmlformats.org/officeDocument/2006/relationships/oleObject" Target="../embeddings/oleObject4.bin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13.wmf"/><Relationship Id="rId22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18" Type="http://schemas.openxmlformats.org/officeDocument/2006/relationships/image" Target="../media/image40.tiff"/><Relationship Id="rId3" Type="http://schemas.openxmlformats.org/officeDocument/2006/relationships/image" Target="../media/image25.png"/><Relationship Id="rId21" Type="http://schemas.openxmlformats.org/officeDocument/2006/relationships/image" Target="../media/image43.tiff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17" Type="http://schemas.openxmlformats.org/officeDocument/2006/relationships/image" Target="../media/image39.tiff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38.png"/><Relationship Id="rId20" Type="http://schemas.openxmlformats.org/officeDocument/2006/relationships/image" Target="../media/image42.tif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10" Type="http://schemas.openxmlformats.org/officeDocument/2006/relationships/image" Target="../media/image32.png"/><Relationship Id="rId19" Type="http://schemas.openxmlformats.org/officeDocument/2006/relationships/image" Target="../media/image41.tiff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Relationship Id="rId22" Type="http://schemas.openxmlformats.org/officeDocument/2006/relationships/image" Target="../media/image44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13" Type="http://schemas.openxmlformats.org/officeDocument/2006/relationships/image" Target="../media/image55.png"/><Relationship Id="rId18" Type="http://schemas.openxmlformats.org/officeDocument/2006/relationships/image" Target="../media/image60.png"/><Relationship Id="rId3" Type="http://schemas.openxmlformats.org/officeDocument/2006/relationships/image" Target="../media/image45.png"/><Relationship Id="rId21" Type="http://schemas.openxmlformats.org/officeDocument/2006/relationships/image" Target="../media/image63.png"/><Relationship Id="rId7" Type="http://schemas.openxmlformats.org/officeDocument/2006/relationships/image" Target="../media/image49.png"/><Relationship Id="rId12" Type="http://schemas.openxmlformats.org/officeDocument/2006/relationships/image" Target="../media/image54.png"/><Relationship Id="rId17" Type="http://schemas.openxmlformats.org/officeDocument/2006/relationships/image" Target="../media/image59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58.png"/><Relationship Id="rId20" Type="http://schemas.openxmlformats.org/officeDocument/2006/relationships/image" Target="../media/image62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8.png"/><Relationship Id="rId11" Type="http://schemas.openxmlformats.org/officeDocument/2006/relationships/image" Target="../media/image53.png"/><Relationship Id="rId5" Type="http://schemas.openxmlformats.org/officeDocument/2006/relationships/image" Target="../media/image47.png"/><Relationship Id="rId15" Type="http://schemas.openxmlformats.org/officeDocument/2006/relationships/image" Target="../media/image57.png"/><Relationship Id="rId10" Type="http://schemas.openxmlformats.org/officeDocument/2006/relationships/image" Target="../media/image52.png"/><Relationship Id="rId19" Type="http://schemas.openxmlformats.org/officeDocument/2006/relationships/image" Target="../media/image61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Relationship Id="rId14" Type="http://schemas.openxmlformats.org/officeDocument/2006/relationships/image" Target="../media/image56.png"/><Relationship Id="rId22" Type="http://schemas.openxmlformats.org/officeDocument/2006/relationships/image" Target="../media/image6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13" Type="http://schemas.openxmlformats.org/officeDocument/2006/relationships/image" Target="../media/image66.emf"/><Relationship Id="rId18" Type="http://schemas.openxmlformats.org/officeDocument/2006/relationships/image" Target="../media/image72.png"/><Relationship Id="rId3" Type="http://schemas.openxmlformats.org/officeDocument/2006/relationships/notesSlide" Target="../notesSlides/notesSlide7.xml"/><Relationship Id="rId21" Type="http://schemas.openxmlformats.org/officeDocument/2006/relationships/image" Target="../media/image74.png"/><Relationship Id="rId7" Type="http://schemas.microsoft.com/office/2007/relationships/hdphoto" Target="../media/hdphoto4.wdp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68.emf"/><Relationship Id="rId2" Type="http://schemas.openxmlformats.org/officeDocument/2006/relationships/slideLayout" Target="../slideLayouts/slideLayout6.xml"/><Relationship Id="rId16" Type="http://schemas.openxmlformats.org/officeDocument/2006/relationships/oleObject" Target="../embeddings/oleObject9.bin"/><Relationship Id="rId20" Type="http://schemas.microsoft.com/office/2007/relationships/hdphoto" Target="../media/hdphoto6.wdp"/><Relationship Id="rId1" Type="http://schemas.openxmlformats.org/officeDocument/2006/relationships/vmlDrawing" Target="../drawings/vmlDrawing2.vml"/><Relationship Id="rId6" Type="http://schemas.openxmlformats.org/officeDocument/2006/relationships/image" Target="../media/image70.png"/><Relationship Id="rId11" Type="http://schemas.openxmlformats.org/officeDocument/2006/relationships/image" Target="../media/image65.emf"/><Relationship Id="rId5" Type="http://schemas.microsoft.com/office/2007/relationships/hdphoto" Target="../media/hdphoto3.wdp"/><Relationship Id="rId15" Type="http://schemas.openxmlformats.org/officeDocument/2006/relationships/image" Target="../media/image67.emf"/><Relationship Id="rId10" Type="http://schemas.openxmlformats.org/officeDocument/2006/relationships/oleObject" Target="../embeddings/oleObject6.bin"/><Relationship Id="rId19" Type="http://schemas.openxmlformats.org/officeDocument/2006/relationships/image" Target="../media/image73.png"/><Relationship Id="rId4" Type="http://schemas.openxmlformats.org/officeDocument/2006/relationships/image" Target="../media/image69.png"/><Relationship Id="rId9" Type="http://schemas.microsoft.com/office/2007/relationships/hdphoto" Target="../media/hdphoto5.wdp"/><Relationship Id="rId14" Type="http://schemas.openxmlformats.org/officeDocument/2006/relationships/oleObject" Target="../embeddings/oleObject8.bin"/><Relationship Id="rId22" Type="http://schemas.microsoft.com/office/2007/relationships/hdphoto" Target="../media/hdphoto7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wmf"/><Relationship Id="rId13" Type="http://schemas.openxmlformats.org/officeDocument/2006/relationships/image" Target="../media/image82.png"/><Relationship Id="rId18" Type="http://schemas.microsoft.com/office/2007/relationships/hdphoto" Target="../media/hdphoto9.wdp"/><Relationship Id="rId3" Type="http://schemas.openxmlformats.org/officeDocument/2006/relationships/notesSlide" Target="../notesSlides/notesSlide8.xml"/><Relationship Id="rId21" Type="http://schemas.openxmlformats.org/officeDocument/2006/relationships/image" Target="../media/image86.png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81.png"/><Relationship Id="rId17" Type="http://schemas.openxmlformats.org/officeDocument/2006/relationships/image" Target="../media/image85.png"/><Relationship Id="rId2" Type="http://schemas.openxmlformats.org/officeDocument/2006/relationships/slideLayout" Target="../slideLayouts/slideLayout6.xml"/><Relationship Id="rId16" Type="http://schemas.microsoft.com/office/2007/relationships/hdphoto" Target="../media/hdphoto8.wdp"/><Relationship Id="rId20" Type="http://schemas.openxmlformats.org/officeDocument/2006/relationships/image" Target="../media/image78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75.wmf"/><Relationship Id="rId11" Type="http://schemas.openxmlformats.org/officeDocument/2006/relationships/image" Target="../media/image80.png"/><Relationship Id="rId5" Type="http://schemas.openxmlformats.org/officeDocument/2006/relationships/oleObject" Target="../embeddings/oleObject10.bin"/><Relationship Id="rId15" Type="http://schemas.openxmlformats.org/officeDocument/2006/relationships/image" Target="../media/image84.png"/><Relationship Id="rId10" Type="http://schemas.openxmlformats.org/officeDocument/2006/relationships/image" Target="../media/image77.wmf"/><Relationship Id="rId19" Type="http://schemas.openxmlformats.org/officeDocument/2006/relationships/oleObject" Target="../embeddings/oleObject13.bin"/><Relationship Id="rId4" Type="http://schemas.openxmlformats.org/officeDocument/2006/relationships/image" Target="../media/image79.png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83.png"/><Relationship Id="rId22" Type="http://schemas.openxmlformats.org/officeDocument/2006/relationships/image" Target="../media/image87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9.e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94.wmf"/><Relationship Id="rId3" Type="http://schemas.openxmlformats.org/officeDocument/2006/relationships/notesSlide" Target="../notesSlides/notesSlide9.xml"/><Relationship Id="rId21" Type="http://schemas.openxmlformats.org/officeDocument/2006/relationships/oleObject" Target="../embeddings/oleObject22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91.emf"/><Relationship Id="rId17" Type="http://schemas.openxmlformats.org/officeDocument/2006/relationships/oleObject" Target="../embeddings/oleObject20.bin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93.emf"/><Relationship Id="rId20" Type="http://schemas.openxmlformats.org/officeDocument/2006/relationships/image" Target="../media/image95.w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88.emf"/><Relationship Id="rId11" Type="http://schemas.openxmlformats.org/officeDocument/2006/relationships/oleObject" Target="../embeddings/oleObject17.bin"/><Relationship Id="rId24" Type="http://schemas.openxmlformats.org/officeDocument/2006/relationships/image" Target="../media/image97.emf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23" Type="http://schemas.openxmlformats.org/officeDocument/2006/relationships/oleObject" Target="../embeddings/oleObject23.bin"/><Relationship Id="rId10" Type="http://schemas.openxmlformats.org/officeDocument/2006/relationships/image" Target="../media/image90.emf"/><Relationship Id="rId19" Type="http://schemas.openxmlformats.org/officeDocument/2006/relationships/oleObject" Target="../embeddings/oleObject21.bin"/><Relationship Id="rId4" Type="http://schemas.openxmlformats.org/officeDocument/2006/relationships/image" Target="../media/image98.png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92.emf"/><Relationship Id="rId22" Type="http://schemas.openxmlformats.org/officeDocument/2006/relationships/image" Target="../media/image9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4A77DF52-27F3-4A8B-82A5-44F76D932D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4598053"/>
              </p:ext>
            </p:extLst>
          </p:nvPr>
        </p:nvGraphicFramePr>
        <p:xfrm>
          <a:off x="300039" y="406659"/>
          <a:ext cx="6200774" cy="712946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40261">
                  <a:extLst>
                    <a:ext uri="{9D8B030D-6E8A-4147-A177-3AD203B41FA5}">
                      <a16:colId xmlns:a16="http://schemas.microsoft.com/office/drawing/2014/main" val="1089014227"/>
                    </a:ext>
                  </a:extLst>
                </a:gridCol>
                <a:gridCol w="1729897">
                  <a:extLst>
                    <a:ext uri="{9D8B030D-6E8A-4147-A177-3AD203B41FA5}">
                      <a16:colId xmlns:a16="http://schemas.microsoft.com/office/drawing/2014/main" val="1875824103"/>
                    </a:ext>
                  </a:extLst>
                </a:gridCol>
                <a:gridCol w="1730616">
                  <a:extLst>
                    <a:ext uri="{9D8B030D-6E8A-4147-A177-3AD203B41FA5}">
                      <a16:colId xmlns:a16="http://schemas.microsoft.com/office/drawing/2014/main" val="1320584910"/>
                    </a:ext>
                  </a:extLst>
                </a:gridCol>
              </a:tblGrid>
              <a:tr h="592490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– median (</a:t>
                      </a:r>
                      <a:r>
                        <a:rPr lang="en-US" sz="105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QR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 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-67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85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45674463"/>
                  </a:ext>
                </a:extLst>
              </a:tr>
              <a:tr h="367892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 gender – n (%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6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44) 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49223714"/>
                  </a:ext>
                </a:extLst>
              </a:tr>
              <a:tr h="386615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n (%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8512109"/>
                  </a:ext>
                </a:extLst>
              </a:tr>
              <a:tr h="386615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lipidemia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n (%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47791379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 mass index – median (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Q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89535" marR="90170" algn="ctr">
                        <a:spcBef>
                          <a:spcPts val="15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4 (21.2-31.2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89535" marR="90170" algn="ctr">
                        <a:spcBef>
                          <a:spcPts val="15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18(21.6-49.6) 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8736783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 – median (IQR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-34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-198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80689320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 – median (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Q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-31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-260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35721626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ilirubin – median (IQR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-0.8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-4.3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98457337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R – median (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Q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-1.2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-1.6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82440588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umin – median (IQR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-3.5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5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-5.1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62374623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 disease – n (%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56360167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malignant disease – n (%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zh-CN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r>
                        <a:rPr lang="zh-CN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）</a:t>
                      </a: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53097792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disease – n (%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 (66)   ***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59901553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let count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n (IQR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(103-245) 10^9/L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(101-433) 10^9/L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04215627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 (IQR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(11.1-14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(11.8-19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52041499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TT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 (IQR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(25.7-37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(25.4-38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4067196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rhosis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 (%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(8) *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9963820"/>
                  </a:ext>
                </a:extLst>
              </a:tr>
              <a:tr h="385418"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platelet or anticoagulation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n (%)</a:t>
                      </a:r>
                      <a:endParaRPr lang="zh-CN" sz="10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(0)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R="43180" algn="ctr">
                        <a:lnSpc>
                          <a:spcPct val="199000"/>
                        </a:lnSpc>
                        <a:spcBef>
                          <a:spcPts val="35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(32) ***</a:t>
                      </a:r>
                      <a:endParaRPr lang="zh-CN" sz="10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04324009"/>
                  </a:ext>
                </a:extLst>
              </a:tr>
            </a:tbl>
          </a:graphicData>
        </a:graphic>
      </p:graphicFrame>
      <p:sp>
        <p:nvSpPr>
          <p:cNvPr id="3" name="矩形 2">
            <a:extLst>
              <a:ext uri="{FF2B5EF4-FFF2-40B4-BE49-F238E27FC236}">
                <a16:creationId xmlns:a16="http://schemas.microsoft.com/office/drawing/2014/main" id="{362048FB-9703-4C0D-88D8-ABC0A33A0D62}"/>
              </a:ext>
            </a:extLst>
          </p:cNvPr>
          <p:cNvSpPr/>
          <p:nvPr/>
        </p:nvSpPr>
        <p:spPr>
          <a:xfrm>
            <a:off x="3126987" y="106619"/>
            <a:ext cx="475320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olunteers n=12      Liver Resection n=49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57525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642356" y="754388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701" y="3423710"/>
            <a:ext cx="3656002" cy="21798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8063" y="6016187"/>
            <a:ext cx="2889251" cy="25861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4157" y="923017"/>
            <a:ext cx="3699546" cy="19508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0" name="TextBox 109"/>
          <p:cNvSpPr txBox="1"/>
          <p:nvPr/>
        </p:nvSpPr>
        <p:spPr>
          <a:xfrm>
            <a:off x="640080" y="3205990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640080" y="5616077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674845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91440" y="473628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" name="组合 7"/>
          <p:cNvGrpSpPr/>
          <p:nvPr/>
        </p:nvGrpSpPr>
        <p:grpSpPr>
          <a:xfrm>
            <a:off x="58861" y="642905"/>
            <a:ext cx="1884127" cy="1919223"/>
            <a:chOff x="58861" y="793033"/>
            <a:chExt cx="1884127" cy="1919223"/>
          </a:xfrm>
        </p:grpSpPr>
        <p:pic>
          <p:nvPicPr>
            <p:cNvPr id="1028" name="Picture 4" descr="C:\Users\zhanghongji\Desktop\Specimen_001_I1R6-D1.fcs_FSC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719" y="793033"/>
              <a:ext cx="1829269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7" name="Straight Arrow Connector 15"/>
            <p:cNvCxnSpPr/>
            <p:nvPr/>
          </p:nvCxnSpPr>
          <p:spPr>
            <a:xfrm flipV="1">
              <a:off x="212750" y="1309991"/>
              <a:ext cx="634" cy="39025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31"/>
            <p:cNvCxnSpPr/>
            <p:nvPr/>
          </p:nvCxnSpPr>
          <p:spPr>
            <a:xfrm>
              <a:off x="1019975" y="2585808"/>
              <a:ext cx="40527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303633" y="2404479"/>
              <a:ext cx="7917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 rot="16200000">
              <a:off x="-183140" y="1871907"/>
              <a:ext cx="7917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</p:grpSp>
      <p:sp>
        <p:nvSpPr>
          <p:cNvPr id="4" name="右箭头 3"/>
          <p:cNvSpPr/>
          <p:nvPr/>
        </p:nvSpPr>
        <p:spPr>
          <a:xfrm>
            <a:off x="1930858" y="1292206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右箭头 56"/>
          <p:cNvSpPr/>
          <p:nvPr/>
        </p:nvSpPr>
        <p:spPr>
          <a:xfrm>
            <a:off x="3510197" y="1514970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右箭头 57"/>
          <p:cNvSpPr/>
          <p:nvPr/>
        </p:nvSpPr>
        <p:spPr>
          <a:xfrm rot="5400000">
            <a:off x="5523787" y="2411622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右箭头 58"/>
          <p:cNvSpPr/>
          <p:nvPr/>
        </p:nvSpPr>
        <p:spPr>
          <a:xfrm rot="8129434">
            <a:off x="4426417" y="2384367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2321414" y="642905"/>
            <a:ext cx="1927740" cy="1908545"/>
            <a:chOff x="2286245" y="793033"/>
            <a:chExt cx="1927740" cy="1908545"/>
          </a:xfrm>
        </p:grpSpPr>
        <p:pic>
          <p:nvPicPr>
            <p:cNvPr id="1027" name="Picture 3" descr="C:\Users\zhanghongji\Desktop\Specimen_001_I1R6-D1.fcs_FSC1.pn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84717" y="793033"/>
              <a:ext cx="1829268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60" name="Straight Arrow Connector 15"/>
            <p:cNvCxnSpPr/>
            <p:nvPr/>
          </p:nvCxnSpPr>
          <p:spPr>
            <a:xfrm flipV="1">
              <a:off x="2440134" y="1287590"/>
              <a:ext cx="634" cy="39025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31"/>
            <p:cNvCxnSpPr/>
            <p:nvPr/>
          </p:nvCxnSpPr>
          <p:spPr>
            <a:xfrm>
              <a:off x="3247359" y="2575130"/>
              <a:ext cx="40527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2531017" y="2393801"/>
              <a:ext cx="7917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2044244" y="1849506"/>
              <a:ext cx="7917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</p:grpSp>
      <p:sp>
        <p:nvSpPr>
          <p:cNvPr id="76" name="右箭头 75"/>
          <p:cNvSpPr/>
          <p:nvPr/>
        </p:nvSpPr>
        <p:spPr>
          <a:xfrm>
            <a:off x="4220676" y="1349609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>
            <a:off x="4674701" y="610407"/>
            <a:ext cx="1951186" cy="1868451"/>
            <a:chOff x="4674701" y="760535"/>
            <a:chExt cx="1951186" cy="1868451"/>
          </a:xfrm>
        </p:grpSpPr>
        <p:grpSp>
          <p:nvGrpSpPr>
            <p:cNvPr id="10" name="组合 9"/>
            <p:cNvGrpSpPr/>
            <p:nvPr/>
          </p:nvGrpSpPr>
          <p:grpSpPr>
            <a:xfrm>
              <a:off x="4674701" y="760535"/>
              <a:ext cx="1951186" cy="1868451"/>
              <a:chOff x="4627809" y="760535"/>
              <a:chExt cx="1951186" cy="1868451"/>
            </a:xfrm>
          </p:grpSpPr>
          <p:pic>
            <p:nvPicPr>
              <p:cNvPr id="1029" name="Picture 5" descr="C:\Users\zhanghongji\Desktop\Specimen_001_I1R6-D1.fcs_FSC_SSC_Platelet.pn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49727" y="760535"/>
                <a:ext cx="1829268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64" name="Straight Arrow Connector 15"/>
              <p:cNvCxnSpPr/>
              <p:nvPr/>
            </p:nvCxnSpPr>
            <p:spPr>
              <a:xfrm flipV="1">
                <a:off x="4781698" y="1144660"/>
                <a:ext cx="634" cy="3902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Arrow Connector 31"/>
              <p:cNvCxnSpPr/>
              <p:nvPr/>
            </p:nvCxnSpPr>
            <p:spPr>
              <a:xfrm>
                <a:off x="5553754" y="2443923"/>
                <a:ext cx="4052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65"/>
              <p:cNvSpPr txBox="1"/>
              <p:nvPr/>
            </p:nvSpPr>
            <p:spPr>
              <a:xfrm>
                <a:off x="4872581" y="2321209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41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 rot="16200000">
                <a:off x="4385808" y="1706576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6147099" y="930293"/>
              <a:ext cx="413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PL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2293212" y="2757313"/>
            <a:ext cx="1974356" cy="1916080"/>
            <a:chOff x="2258043" y="2883995"/>
            <a:chExt cx="1974356" cy="1916080"/>
          </a:xfrm>
        </p:grpSpPr>
        <p:grpSp>
          <p:nvGrpSpPr>
            <p:cNvPr id="15" name="组合 14"/>
            <p:cNvGrpSpPr/>
            <p:nvPr/>
          </p:nvGrpSpPr>
          <p:grpSpPr>
            <a:xfrm>
              <a:off x="2258043" y="2883995"/>
              <a:ext cx="1974356" cy="1916080"/>
              <a:chOff x="2380029" y="3581072"/>
              <a:chExt cx="1974357" cy="1916080"/>
            </a:xfrm>
          </p:grpSpPr>
          <p:pic>
            <p:nvPicPr>
              <p:cNvPr id="1031" name="Picture 7" descr="C:\Users\zhanghongji\Desktop\Specimen_001_I1R6-D2.fcs_Lymphocytes_FSC-A, Comp-PE-G-A subset1.png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45606" y="3581072"/>
                <a:ext cx="180878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72" name="Straight Arrow Connector 15"/>
              <p:cNvCxnSpPr/>
              <p:nvPr/>
            </p:nvCxnSpPr>
            <p:spPr>
              <a:xfrm flipV="1">
                <a:off x="2533918" y="4059718"/>
                <a:ext cx="634" cy="3902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Arrow Connector 31"/>
              <p:cNvCxnSpPr/>
              <p:nvPr/>
            </p:nvCxnSpPr>
            <p:spPr>
              <a:xfrm>
                <a:off x="3399758" y="5370704"/>
                <a:ext cx="4052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TextBox 73"/>
              <p:cNvSpPr txBox="1"/>
              <p:nvPr/>
            </p:nvSpPr>
            <p:spPr>
              <a:xfrm>
                <a:off x="2683416" y="5189375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41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 rot="16200000">
                <a:off x="2138028" y="4621634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y6G</a:t>
                </a:r>
              </a:p>
            </p:txBody>
          </p:sp>
        </p:grpSp>
        <p:sp>
          <p:nvSpPr>
            <p:cNvPr id="78" name="TextBox 77"/>
            <p:cNvSpPr txBox="1"/>
            <p:nvPr/>
          </p:nvSpPr>
          <p:spPr>
            <a:xfrm>
              <a:off x="2691279" y="2970771"/>
              <a:ext cx="15376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PL-N aggregate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4739941" y="2749970"/>
            <a:ext cx="1853735" cy="1926448"/>
            <a:chOff x="4739941" y="2923544"/>
            <a:chExt cx="1853735" cy="1926448"/>
          </a:xfrm>
        </p:grpSpPr>
        <p:grpSp>
          <p:nvGrpSpPr>
            <p:cNvPr id="18" name="组合 17"/>
            <p:cNvGrpSpPr/>
            <p:nvPr/>
          </p:nvGrpSpPr>
          <p:grpSpPr>
            <a:xfrm>
              <a:off x="4739941" y="2923544"/>
              <a:ext cx="1853735" cy="1926448"/>
              <a:chOff x="4751664" y="3052497"/>
              <a:chExt cx="1853735" cy="1926448"/>
            </a:xfrm>
          </p:grpSpPr>
          <p:cxnSp>
            <p:nvCxnSpPr>
              <p:cNvPr id="68" name="Straight Arrow Connector 15"/>
              <p:cNvCxnSpPr/>
              <p:nvPr/>
            </p:nvCxnSpPr>
            <p:spPr>
              <a:xfrm flipV="1">
                <a:off x="4905552" y="3494619"/>
                <a:ext cx="634" cy="3902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Arrow Connector 31"/>
              <p:cNvCxnSpPr/>
              <p:nvPr/>
            </p:nvCxnSpPr>
            <p:spPr>
              <a:xfrm>
                <a:off x="5712777" y="4852497"/>
                <a:ext cx="4052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TextBox 69"/>
              <p:cNvSpPr txBox="1"/>
              <p:nvPr/>
            </p:nvSpPr>
            <p:spPr>
              <a:xfrm>
                <a:off x="4996435" y="4671168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41</a:t>
                </a: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 rot="16200000">
                <a:off x="4447268" y="4052755"/>
                <a:ext cx="9165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62P</a:t>
                </a:r>
              </a:p>
            </p:txBody>
          </p:sp>
          <p:pic>
            <p:nvPicPr>
              <p:cNvPr id="1033" name="Picture 9" descr="C:\Users\zhanghongji\Desktop\Specimen_001_I1R6-D1.fcs_FSC_SSC_Platelet_Comp-PE-G-A, FSC-A subset1.png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96619" y="3052497"/>
                <a:ext cx="180878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80" name="TextBox 79"/>
            <p:cNvSpPr txBox="1"/>
            <p:nvPr/>
          </p:nvSpPr>
          <p:spPr>
            <a:xfrm>
              <a:off x="5360666" y="3026494"/>
              <a:ext cx="10871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D62P+P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8" name="右箭头 127"/>
          <p:cNvSpPr/>
          <p:nvPr/>
        </p:nvSpPr>
        <p:spPr>
          <a:xfrm>
            <a:off x="1920129" y="5313881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右箭头 129"/>
          <p:cNvSpPr/>
          <p:nvPr/>
        </p:nvSpPr>
        <p:spPr>
          <a:xfrm rot="5400000">
            <a:off x="5536680" y="6629343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右箭头 149"/>
          <p:cNvSpPr/>
          <p:nvPr/>
        </p:nvSpPr>
        <p:spPr>
          <a:xfrm>
            <a:off x="4272969" y="5261109"/>
            <a:ext cx="489204" cy="321596"/>
          </a:xfrm>
          <a:prstGeom prst="rightArrow">
            <a:avLst/>
          </a:prstGeom>
          <a:noFill/>
          <a:ln w="19050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71754" y="4513312"/>
            <a:ext cx="1886301" cy="2102415"/>
            <a:chOff x="48308" y="4581379"/>
            <a:chExt cx="1886301" cy="2102415"/>
          </a:xfrm>
        </p:grpSpPr>
        <p:sp>
          <p:nvSpPr>
            <p:cNvPr id="81" name="TextBox 80"/>
            <p:cNvSpPr txBox="1"/>
            <p:nvPr/>
          </p:nvSpPr>
          <p:spPr>
            <a:xfrm>
              <a:off x="67994" y="4581379"/>
              <a:ext cx="2051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22" name="组合 121"/>
            <p:cNvGrpSpPr/>
            <p:nvPr/>
          </p:nvGrpSpPr>
          <p:grpSpPr>
            <a:xfrm>
              <a:off x="48308" y="5281529"/>
              <a:ext cx="1366389" cy="1402265"/>
              <a:chOff x="58861" y="1309991"/>
              <a:chExt cx="1366389" cy="1402265"/>
            </a:xfrm>
          </p:grpSpPr>
          <p:cxnSp>
            <p:nvCxnSpPr>
              <p:cNvPr id="124" name="Straight Arrow Connector 15"/>
              <p:cNvCxnSpPr/>
              <p:nvPr/>
            </p:nvCxnSpPr>
            <p:spPr>
              <a:xfrm flipV="1">
                <a:off x="212750" y="1309991"/>
                <a:ext cx="634" cy="3902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Arrow Connector 31"/>
              <p:cNvCxnSpPr/>
              <p:nvPr/>
            </p:nvCxnSpPr>
            <p:spPr>
              <a:xfrm>
                <a:off x="1019975" y="2585808"/>
                <a:ext cx="4052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6" name="TextBox 125"/>
              <p:cNvSpPr txBox="1"/>
              <p:nvPr/>
            </p:nvSpPr>
            <p:spPr>
              <a:xfrm>
                <a:off x="303633" y="2404479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H</a:t>
                </a: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 rot="16200000">
                <a:off x="-183140" y="1871907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</p:grpSp>
        <p:pic>
          <p:nvPicPr>
            <p:cNvPr id="1034" name="Picture 10" descr="C:\Users\zhanghongji\Desktop\Specimen_001_16_014.fcs_Lymphocytes-1.png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5341" y="4799454"/>
              <a:ext cx="1829268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20" name="组合 19"/>
          <p:cNvGrpSpPr/>
          <p:nvPr/>
        </p:nvGrpSpPr>
        <p:grpSpPr>
          <a:xfrm>
            <a:off x="2322432" y="4736020"/>
            <a:ext cx="1869821" cy="1892475"/>
            <a:chOff x="2310861" y="4780641"/>
            <a:chExt cx="1869821" cy="1892475"/>
          </a:xfrm>
        </p:grpSpPr>
        <p:grpSp>
          <p:nvGrpSpPr>
            <p:cNvPr id="132" name="组合 131"/>
            <p:cNvGrpSpPr/>
            <p:nvPr/>
          </p:nvGrpSpPr>
          <p:grpSpPr>
            <a:xfrm>
              <a:off x="2310861" y="5259128"/>
              <a:ext cx="1366389" cy="1413988"/>
              <a:chOff x="2286245" y="1287590"/>
              <a:chExt cx="1366389" cy="1413988"/>
            </a:xfrm>
          </p:grpSpPr>
          <p:cxnSp>
            <p:nvCxnSpPr>
              <p:cNvPr id="134" name="Straight Arrow Connector 15"/>
              <p:cNvCxnSpPr/>
              <p:nvPr/>
            </p:nvCxnSpPr>
            <p:spPr>
              <a:xfrm flipV="1">
                <a:off x="2440134" y="1287590"/>
                <a:ext cx="634" cy="3902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Arrow Connector 31"/>
              <p:cNvCxnSpPr/>
              <p:nvPr/>
            </p:nvCxnSpPr>
            <p:spPr>
              <a:xfrm>
                <a:off x="3247359" y="2575130"/>
                <a:ext cx="4052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TextBox 135"/>
              <p:cNvSpPr txBox="1"/>
              <p:nvPr/>
            </p:nvSpPr>
            <p:spPr>
              <a:xfrm>
                <a:off x="2531017" y="2393801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H</a:t>
                </a: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 rot="16200000">
                <a:off x="2044244" y="1849506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</p:grpSp>
        <p:pic>
          <p:nvPicPr>
            <p:cNvPr id="1035" name="Picture 11" descr="C:\Users\zhanghongji\Desktop\Specimen_001_16_014.fcs_Lymphocytes_Single Cells_Single Cells.png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1414" y="4780641"/>
              <a:ext cx="1829268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21" name="组合 20"/>
          <p:cNvGrpSpPr/>
          <p:nvPr/>
        </p:nvGrpSpPr>
        <p:grpSpPr>
          <a:xfrm>
            <a:off x="4727615" y="4708730"/>
            <a:ext cx="1842057" cy="1891062"/>
            <a:chOff x="4664148" y="4732908"/>
            <a:chExt cx="1842057" cy="1891062"/>
          </a:xfrm>
        </p:grpSpPr>
        <p:grpSp>
          <p:nvGrpSpPr>
            <p:cNvPr id="138" name="组合 137"/>
            <p:cNvGrpSpPr/>
            <p:nvPr/>
          </p:nvGrpSpPr>
          <p:grpSpPr>
            <a:xfrm>
              <a:off x="4664148" y="5116198"/>
              <a:ext cx="1366389" cy="1507772"/>
              <a:chOff x="4627809" y="1144660"/>
              <a:chExt cx="1366389" cy="1507772"/>
            </a:xfrm>
          </p:grpSpPr>
          <p:cxnSp>
            <p:nvCxnSpPr>
              <p:cNvPr id="140" name="Straight Arrow Connector 15"/>
              <p:cNvCxnSpPr/>
              <p:nvPr/>
            </p:nvCxnSpPr>
            <p:spPr>
              <a:xfrm flipV="1">
                <a:off x="4781698" y="1144660"/>
                <a:ext cx="634" cy="3902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Arrow Connector 31"/>
              <p:cNvCxnSpPr/>
              <p:nvPr/>
            </p:nvCxnSpPr>
            <p:spPr>
              <a:xfrm>
                <a:off x="5588923" y="2502538"/>
                <a:ext cx="4052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TextBox 141"/>
              <p:cNvSpPr txBox="1"/>
              <p:nvPr/>
            </p:nvSpPr>
            <p:spPr>
              <a:xfrm>
                <a:off x="4872581" y="2344655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 rot="16200000">
                <a:off x="4385808" y="1706576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VD</a:t>
                </a:r>
              </a:p>
            </p:txBody>
          </p:sp>
        </p:grpSp>
        <p:pic>
          <p:nvPicPr>
            <p:cNvPr id="1036" name="Picture 12" descr="C:\Users\zhanghongji\Desktop\Specimen_001_16_014.fcs_Lymphocytes_Single Cells_Single Cells_Single Cells_CD45, VIAB subset-1.png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97425" y="4732908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25" name="组合 24"/>
          <p:cNvGrpSpPr/>
          <p:nvPr/>
        </p:nvGrpSpPr>
        <p:grpSpPr>
          <a:xfrm>
            <a:off x="4692446" y="7023020"/>
            <a:ext cx="1855061" cy="1870158"/>
            <a:chOff x="4692446" y="7067641"/>
            <a:chExt cx="1855061" cy="1870158"/>
          </a:xfrm>
        </p:grpSpPr>
        <p:grpSp>
          <p:nvGrpSpPr>
            <p:cNvPr id="153" name="组合 152"/>
            <p:cNvGrpSpPr/>
            <p:nvPr/>
          </p:nvGrpSpPr>
          <p:grpSpPr>
            <a:xfrm>
              <a:off x="4692446" y="7453473"/>
              <a:ext cx="1366388" cy="1484326"/>
              <a:chOff x="4751664" y="3494619"/>
              <a:chExt cx="1366388" cy="1484326"/>
            </a:xfrm>
          </p:grpSpPr>
          <p:cxnSp>
            <p:nvCxnSpPr>
              <p:cNvPr id="154" name="Straight Arrow Connector 15"/>
              <p:cNvCxnSpPr/>
              <p:nvPr/>
            </p:nvCxnSpPr>
            <p:spPr>
              <a:xfrm flipV="1">
                <a:off x="4905552" y="3494619"/>
                <a:ext cx="634" cy="39025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Arrow Connector 31"/>
              <p:cNvCxnSpPr/>
              <p:nvPr/>
            </p:nvCxnSpPr>
            <p:spPr>
              <a:xfrm>
                <a:off x="5712777" y="4852497"/>
                <a:ext cx="405275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TextBox 155"/>
              <p:cNvSpPr txBox="1"/>
              <p:nvPr/>
            </p:nvSpPr>
            <p:spPr>
              <a:xfrm>
                <a:off x="4996435" y="4671168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y6G</a:t>
                </a: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 rot="16200000">
                <a:off x="4447268" y="4052755"/>
                <a:ext cx="9165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</p:grpSp>
        <p:pic>
          <p:nvPicPr>
            <p:cNvPr id="1037" name="Picture 13" descr="C:\Users\zhanghongji\Desktop\Specimen_001_16_014.fcs_Lymphocytes_Single Cells_Single Cells_Single Cells_CD45, VIAB subset_CD45, VIAB subset-1.png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38727" y="7067641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71" name="TextBox 170"/>
          <p:cNvSpPr txBox="1"/>
          <p:nvPr/>
        </p:nvSpPr>
        <p:spPr>
          <a:xfrm>
            <a:off x="5305762" y="4979369"/>
            <a:ext cx="1225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ive CD45+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5479453" y="7913657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eutrophi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8525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13589" y="695035"/>
            <a:ext cx="1388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194370" y="670383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0FB314D3-496A-49DB-B424-213D799DA804}"/>
              </a:ext>
            </a:extLst>
          </p:cNvPr>
          <p:cNvGrpSpPr/>
          <p:nvPr/>
        </p:nvGrpSpPr>
        <p:grpSpPr>
          <a:xfrm>
            <a:off x="220742" y="6326739"/>
            <a:ext cx="2830704" cy="2700654"/>
            <a:chOff x="3859654" y="5703599"/>
            <a:chExt cx="2830704" cy="2700654"/>
          </a:xfrm>
        </p:grpSpPr>
        <p:grpSp>
          <p:nvGrpSpPr>
            <p:cNvPr id="4" name="组合 3"/>
            <p:cNvGrpSpPr/>
            <p:nvPr/>
          </p:nvGrpSpPr>
          <p:grpSpPr>
            <a:xfrm>
              <a:off x="3859654" y="5703599"/>
              <a:ext cx="2830704" cy="2700654"/>
              <a:chOff x="-5017135" y="830923"/>
              <a:chExt cx="3253088" cy="4262137"/>
            </a:xfrm>
          </p:grpSpPr>
          <p:pic>
            <p:nvPicPr>
              <p:cNvPr id="5124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5017134" y="1252126"/>
                <a:ext cx="1594975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125" name="Picture 5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3359022" y="1252126"/>
                <a:ext cx="1594975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126" name="Picture 6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5017135" y="3266781"/>
                <a:ext cx="1594975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127" name="Picture 7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3373392" y="3293060"/>
                <a:ext cx="1594975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3" name="TextBox 52"/>
              <p:cNvSpPr txBox="1"/>
              <p:nvPr/>
            </p:nvSpPr>
            <p:spPr>
              <a:xfrm>
                <a:off x="-4751154" y="830923"/>
                <a:ext cx="1164217" cy="5343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solidFill>
                      <a:srgbClr val="24213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-3098046" y="846149"/>
                <a:ext cx="1087387" cy="5343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solidFill>
                      <a:srgbClr val="24213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h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-3104738" y="2962268"/>
                <a:ext cx="853565" cy="5343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solidFill>
                      <a:srgbClr val="24213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h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-4646430" y="2954471"/>
                <a:ext cx="853565" cy="5343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solidFill>
                      <a:srgbClr val="24213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h</a:t>
                </a:r>
              </a:p>
            </p:txBody>
          </p:sp>
        </p:grpSp>
        <p:cxnSp>
          <p:nvCxnSpPr>
            <p:cNvPr id="21" name="直接箭头连接符 20"/>
            <p:cNvCxnSpPr/>
            <p:nvPr/>
          </p:nvCxnSpPr>
          <p:spPr>
            <a:xfrm flipH="1">
              <a:off x="5529567" y="6678962"/>
              <a:ext cx="12463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箭头连接符 27"/>
            <p:cNvCxnSpPr/>
            <p:nvPr/>
          </p:nvCxnSpPr>
          <p:spPr>
            <a:xfrm flipV="1">
              <a:off x="6132129" y="6198316"/>
              <a:ext cx="163120" cy="3767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箭头连接符 28"/>
            <p:cNvCxnSpPr/>
            <p:nvPr/>
          </p:nvCxnSpPr>
          <p:spPr>
            <a:xfrm flipH="1">
              <a:off x="5722253" y="6084723"/>
              <a:ext cx="12463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/>
            <p:cNvCxnSpPr/>
            <p:nvPr/>
          </p:nvCxnSpPr>
          <p:spPr>
            <a:xfrm flipV="1">
              <a:off x="6052808" y="6464563"/>
              <a:ext cx="104505" cy="1524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箭头连接符 30"/>
            <p:cNvCxnSpPr/>
            <p:nvPr/>
          </p:nvCxnSpPr>
          <p:spPr>
            <a:xfrm flipH="1">
              <a:off x="4709199" y="7992294"/>
              <a:ext cx="12463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箭头连接符 31"/>
            <p:cNvCxnSpPr/>
            <p:nvPr/>
          </p:nvCxnSpPr>
          <p:spPr>
            <a:xfrm flipV="1">
              <a:off x="4709199" y="7746055"/>
              <a:ext cx="120544" cy="1524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箭头连接符 32"/>
            <p:cNvCxnSpPr/>
            <p:nvPr/>
          </p:nvCxnSpPr>
          <p:spPr>
            <a:xfrm flipV="1">
              <a:off x="5784572" y="7476132"/>
              <a:ext cx="0" cy="1524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/>
            <p:cNvCxnSpPr/>
            <p:nvPr/>
          </p:nvCxnSpPr>
          <p:spPr>
            <a:xfrm flipV="1">
              <a:off x="6015395" y="7570556"/>
              <a:ext cx="48134" cy="16377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extBox 25"/>
          <p:cNvSpPr txBox="1"/>
          <p:nvPr/>
        </p:nvSpPr>
        <p:spPr>
          <a:xfrm>
            <a:off x="0" y="3366795"/>
            <a:ext cx="2465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-14204" y="6090439"/>
            <a:ext cx="2465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8" name="TextBox 25">
            <a:extLst>
              <a:ext uri="{FF2B5EF4-FFF2-40B4-BE49-F238E27FC236}">
                <a16:creationId xmlns:a16="http://schemas.microsoft.com/office/drawing/2014/main" id="{57B8968F-68CA-4932-9ABA-726A50609FF4}"/>
              </a:ext>
            </a:extLst>
          </p:cNvPr>
          <p:cNvSpPr txBox="1"/>
          <p:nvPr/>
        </p:nvSpPr>
        <p:spPr>
          <a:xfrm>
            <a:off x="4457103" y="3281429"/>
            <a:ext cx="2465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39" name="Picture 2">
            <a:extLst>
              <a:ext uri="{FF2B5EF4-FFF2-40B4-BE49-F238E27FC236}">
                <a16:creationId xmlns:a16="http://schemas.microsoft.com/office/drawing/2014/main" id="{0DE209B3-D6EC-40C7-AC4E-7906B65DF3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8317" y="3629482"/>
            <a:ext cx="2279683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TextBox 51">
            <a:extLst>
              <a:ext uri="{FF2B5EF4-FFF2-40B4-BE49-F238E27FC236}">
                <a16:creationId xmlns:a16="http://schemas.microsoft.com/office/drawing/2014/main" id="{8568E649-3261-4E8E-8EC9-CD0A7CBB90DF}"/>
              </a:ext>
            </a:extLst>
          </p:cNvPr>
          <p:cNvSpPr txBox="1"/>
          <p:nvPr/>
        </p:nvSpPr>
        <p:spPr>
          <a:xfrm>
            <a:off x="4801679" y="621841"/>
            <a:ext cx="2465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49" name="Picture 4" descr="H:\4.IF.12.2019\77LM87 Julie CD41-gr Fibribogen-red\after talking with Hai\LIVER\4-1 LV_blue-nuclei_green-CD41_red-fibrinogen_white-actin_20x2z_3x3-400X400 25UN BAR.tif">
            <a:extLst>
              <a:ext uri="{FF2B5EF4-FFF2-40B4-BE49-F238E27FC236}">
                <a16:creationId xmlns:a16="http://schemas.microsoft.com/office/drawing/2014/main" id="{3DE871AA-63EF-484E-9F5B-FE208BAB2F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8938" y="6766249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5" descr="H:\4.IF.12.2019\77LM87 Julie CD41-gr Fibribogen-red\after talking with Hai\LIVER\2LV_blue-nuclei_green-CD41_red-fibrinogen_white-actin_20x2z_3x3-400X400 25UN BAR.tif">
            <a:extLst>
              <a:ext uri="{FF2B5EF4-FFF2-40B4-BE49-F238E27FC236}">
                <a16:creationId xmlns:a16="http://schemas.microsoft.com/office/drawing/2014/main" id="{03E63471-9906-4855-BC11-C4A791B6EB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7844" y="6766249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D3A07637-DD51-4265-8CB6-A034538FC430}"/>
              </a:ext>
            </a:extLst>
          </p:cNvPr>
          <p:cNvCxnSpPr/>
          <p:nvPr/>
        </p:nvCxnSpPr>
        <p:spPr>
          <a:xfrm flipH="1">
            <a:off x="6421695" y="7973659"/>
            <a:ext cx="263327" cy="0"/>
          </a:xfrm>
          <a:prstGeom prst="straightConnector1">
            <a:avLst/>
          </a:prstGeom>
          <a:ln w="28575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FB9CF5F8-2297-448C-8EAE-19794BEE0C96}"/>
              </a:ext>
            </a:extLst>
          </p:cNvPr>
          <p:cNvCxnSpPr/>
          <p:nvPr/>
        </p:nvCxnSpPr>
        <p:spPr>
          <a:xfrm flipH="1">
            <a:off x="5198816" y="7841578"/>
            <a:ext cx="263327" cy="0"/>
          </a:xfrm>
          <a:prstGeom prst="straightConnector1">
            <a:avLst/>
          </a:prstGeom>
          <a:ln w="28575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矩形 58">
            <a:extLst>
              <a:ext uri="{FF2B5EF4-FFF2-40B4-BE49-F238E27FC236}">
                <a16:creationId xmlns:a16="http://schemas.microsoft.com/office/drawing/2014/main" id="{AEE5483B-A3E1-472E-A4B1-E200DF9701B5}"/>
              </a:ext>
            </a:extLst>
          </p:cNvPr>
          <p:cNvSpPr/>
          <p:nvPr/>
        </p:nvSpPr>
        <p:spPr>
          <a:xfrm>
            <a:off x="3079509" y="6705108"/>
            <a:ext cx="127951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: Sham</a:t>
            </a: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8E63D7E6-2995-401F-98B2-B714BF9615DA}"/>
              </a:ext>
            </a:extLst>
          </p:cNvPr>
          <p:cNvSpPr/>
          <p:nvPr/>
        </p:nvSpPr>
        <p:spPr>
          <a:xfrm>
            <a:off x="4918188" y="6712496"/>
            <a:ext cx="41229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250CD7C0-EB73-43B8-9A38-DBDA74AD6C7F}"/>
              </a:ext>
            </a:extLst>
          </p:cNvPr>
          <p:cNvSpPr/>
          <p:nvPr/>
        </p:nvSpPr>
        <p:spPr>
          <a:xfrm>
            <a:off x="3353910" y="8667131"/>
            <a:ext cx="283763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1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brinogen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26">
            <a:extLst>
              <a:ext uri="{FF2B5EF4-FFF2-40B4-BE49-F238E27FC236}">
                <a16:creationId xmlns:a16="http://schemas.microsoft.com/office/drawing/2014/main" id="{06EF7A0D-1C03-467D-8C26-AC8FA9292311}"/>
              </a:ext>
            </a:extLst>
          </p:cNvPr>
          <p:cNvSpPr txBox="1"/>
          <p:nvPr/>
        </p:nvSpPr>
        <p:spPr>
          <a:xfrm>
            <a:off x="3059730" y="6099482"/>
            <a:ext cx="2465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aphicFrame>
        <p:nvGraphicFramePr>
          <p:cNvPr id="41" name="对象 40">
            <a:extLst>
              <a:ext uri="{FF2B5EF4-FFF2-40B4-BE49-F238E27FC236}">
                <a16:creationId xmlns:a16="http://schemas.microsoft.com/office/drawing/2014/main" id="{DF06609D-58A0-4908-BE53-A168437B0E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8010420"/>
              </p:ext>
            </p:extLst>
          </p:nvPr>
        </p:nvGraphicFramePr>
        <p:xfrm>
          <a:off x="4578317" y="769535"/>
          <a:ext cx="2343150" cy="2027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4" name="Prism Project" r:id="rId13" imgW="3396960" imgH="2937960" progId="Prism5.Document">
                  <p:embed/>
                </p:oleObj>
              </mc:Choice>
              <mc:Fallback>
                <p:oleObj name="Prism Project" r:id="rId13" imgW="3396960" imgH="2937960" progId="Prism5.Document">
                  <p:embed/>
                  <p:pic>
                    <p:nvPicPr>
                      <p:cNvPr id="13" name="对象 12">
                        <a:extLst>
                          <a:ext uri="{FF2B5EF4-FFF2-40B4-BE49-F238E27FC236}">
                            <a16:creationId xmlns:a16="http://schemas.microsoft.com/office/drawing/2014/main" id="{B13DF67D-743D-46B3-92DC-60F7449C21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578317" y="769535"/>
                        <a:ext cx="2343150" cy="2027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对象 41">
            <a:extLst>
              <a:ext uri="{FF2B5EF4-FFF2-40B4-BE49-F238E27FC236}">
                <a16:creationId xmlns:a16="http://schemas.microsoft.com/office/drawing/2014/main" id="{A70023B7-225E-42DE-99EE-6304E9C920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7820400"/>
              </p:ext>
            </p:extLst>
          </p:nvPr>
        </p:nvGraphicFramePr>
        <p:xfrm>
          <a:off x="2518401" y="494525"/>
          <a:ext cx="2185269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5" name="Prism Project" r:id="rId15" imgW="3277800" imgH="3427200" progId="Prism5.Document">
                  <p:embed/>
                </p:oleObj>
              </mc:Choice>
              <mc:Fallback>
                <p:oleObj name="Prism Project" r:id="rId15" imgW="3277800" imgH="3427200" progId="Prism5.Document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id="{CBA1CA6C-D12B-4727-B32C-654FFF1F1D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518401" y="494525"/>
                        <a:ext cx="2185269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对象 42">
            <a:extLst>
              <a:ext uri="{FF2B5EF4-FFF2-40B4-BE49-F238E27FC236}">
                <a16:creationId xmlns:a16="http://schemas.microsoft.com/office/drawing/2014/main" id="{8904CDBC-AF2C-4955-A969-AAE528EA29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6897184"/>
              </p:ext>
            </p:extLst>
          </p:nvPr>
        </p:nvGraphicFramePr>
        <p:xfrm>
          <a:off x="316315" y="510772"/>
          <a:ext cx="1934673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6" name="Prism Project" r:id="rId17" imgW="3090600" imgH="3655800" progId="Prism5.Document">
                  <p:embed/>
                </p:oleObj>
              </mc:Choice>
              <mc:Fallback>
                <p:oleObj name="Prism Project" r:id="rId17" imgW="3090600" imgH="3655800" progId="Prism5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ABB3E50A-84B6-4BA1-8D4A-A0830816F1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16315" y="510772"/>
                        <a:ext cx="1934673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对象 43">
            <a:extLst>
              <a:ext uri="{FF2B5EF4-FFF2-40B4-BE49-F238E27FC236}">
                <a16:creationId xmlns:a16="http://schemas.microsoft.com/office/drawing/2014/main" id="{D62F4279-498D-4953-9B6C-55161D951B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1033948"/>
              </p:ext>
            </p:extLst>
          </p:nvPr>
        </p:nvGraphicFramePr>
        <p:xfrm>
          <a:off x="84316" y="3783432"/>
          <a:ext cx="2110054" cy="2011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7" name="Prism Project" r:id="rId19" imgW="3543120" imgH="3377160" progId="Prism5.Document">
                  <p:embed/>
                </p:oleObj>
              </mc:Choice>
              <mc:Fallback>
                <p:oleObj name="Prism Project" r:id="rId19" imgW="3543120" imgH="3377160" progId="Prism5.Document">
                  <p:embed/>
                  <p:pic>
                    <p:nvPicPr>
                      <p:cNvPr id="16" name="对象 15">
                        <a:extLst>
                          <a:ext uri="{FF2B5EF4-FFF2-40B4-BE49-F238E27FC236}">
                            <a16:creationId xmlns:a16="http://schemas.microsoft.com/office/drawing/2014/main" id="{E459204E-79E1-487B-A0AD-D3CC8A6511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4316" y="3783432"/>
                        <a:ext cx="2110054" cy="2011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对象 45">
            <a:extLst>
              <a:ext uri="{FF2B5EF4-FFF2-40B4-BE49-F238E27FC236}">
                <a16:creationId xmlns:a16="http://schemas.microsoft.com/office/drawing/2014/main" id="{FE9181BA-9AD2-449E-8664-BF91B2F048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7364091"/>
              </p:ext>
            </p:extLst>
          </p:nvPr>
        </p:nvGraphicFramePr>
        <p:xfrm>
          <a:off x="2356975" y="3777802"/>
          <a:ext cx="2190368" cy="2011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8" name="Prism Project" r:id="rId21" imgW="3492000" imgH="3204000" progId="Prism5.Document">
                  <p:embed/>
                </p:oleObj>
              </mc:Choice>
              <mc:Fallback>
                <p:oleObj name="Prism Project" r:id="rId21" imgW="3492000" imgH="3204000" progId="Prism5.Document">
                  <p:embed/>
                  <p:pic>
                    <p:nvPicPr>
                      <p:cNvPr id="17" name="对象 16">
                        <a:extLst>
                          <a:ext uri="{FF2B5EF4-FFF2-40B4-BE49-F238E27FC236}">
                            <a16:creationId xmlns:a16="http://schemas.microsoft.com/office/drawing/2014/main" id="{4D5BE618-8EFC-4E97-93AF-110DD91E65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356975" y="3777802"/>
                        <a:ext cx="2190368" cy="2011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387176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-67747" y="769999"/>
            <a:ext cx="91790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grpSp>
        <p:nvGrpSpPr>
          <p:cNvPr id="5" name="组合 4"/>
          <p:cNvGrpSpPr/>
          <p:nvPr/>
        </p:nvGrpSpPr>
        <p:grpSpPr>
          <a:xfrm>
            <a:off x="395061" y="598467"/>
            <a:ext cx="6454290" cy="1800000"/>
            <a:chOff x="302036" y="1157493"/>
            <a:chExt cx="6454290" cy="1800000"/>
          </a:xfrm>
        </p:grpSpPr>
        <p:pic>
          <p:nvPicPr>
            <p:cNvPr id="38" name="Picture 15" descr="C:\Users\zhanghongji\Desktop\Specimen_001_11_016.fcs_Lymphocytes_Single Cells_FSC-A, VIAB subset_FSC-A, CD45 subset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2036" y="1157493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9" name="Picture 7" descr="C:\Users\zhanghongji\Desktop\Specimen_001_16_014.fcs_Lymphocytes_Single Cells_FSC-A, VIAB subset_FSC-A, CD45 subset.pn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51545" y="1157493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0" name="Picture 4" descr="C:\Users\zhanghongji\Desktop\Specimen_001_13_011.fcs_Lymphocytes_Single Cells_FSC-A, VIAB subset_FSC-A, CD45 subset.png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9545" y="1157493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" name="Picture 16" descr="C:\Users\zhanghongji\Desktop\Specimen_001_12_009.fcs_Lymphocytes_Single Cells_FSC-A, VIAB subset_FSC-A, CD45 subset.png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47545" y="1157493"/>
              <a:ext cx="1808781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132334" y="2187257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62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907770" y="2198980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9.88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795265" y="2198981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2.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271667" y="2215293"/>
              <a:ext cx="10205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0.9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" name="TextBox 77"/>
          <p:cNvSpPr txBox="1"/>
          <p:nvPr/>
        </p:nvSpPr>
        <p:spPr>
          <a:xfrm>
            <a:off x="74252" y="2195530"/>
            <a:ext cx="6428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396570" y="2139326"/>
            <a:ext cx="6452780" cy="1801825"/>
            <a:chOff x="280810" y="3776003"/>
            <a:chExt cx="6452780" cy="1801825"/>
          </a:xfrm>
        </p:grpSpPr>
        <p:pic>
          <p:nvPicPr>
            <p:cNvPr id="80" name="Picture 2" descr="C:\Users\zhanghongji\Desktop\lung\neu\lung_lung  sham-1.fcs_Lymphocytes_Single Cells_FSC-A, Comp-APC-Cy7-A subset_FSC-A, Comp-PE-Cy7-G-A subset.pn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0810" y="3776003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2" name="Picture 11" descr="C:\Users\zhanghongji\Desktop\lung\neu\lung_lung IR12+DNASE B.fcs_Lymphocytes_Single Cells_FSC-A, Comp-APC-Cy7-A subset_FSC-A, Comp-PE-Cy7-G-A subset1.pn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8810" y="3777828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3" name="Picture 14" descr="C:\Users\zhanghongji\Desktop\lung\neu\lung_lung IR24+DNASE B.fcs_Lymphocytes_Single Cells_FSC-A, Comp-APC-Cy7-A subset_FSC-A, Comp-PE-Cy7-G-A subset1.pn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76810" y="3777828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8" name="Picture 8" descr="C:\Users\zhanghongji\Desktop\lung\neu\lung_lung IR 6 DNASE B.fcs_Lymphocytes_Single Cells_FSC-A, Comp-APC-Cy7-A subset_FSC-A, Comp-PE-Cy7-G-A subset1.pn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24810" y="3777828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9" name="TextBox 88"/>
            <p:cNvSpPr txBox="1"/>
            <p:nvPr/>
          </p:nvSpPr>
          <p:spPr>
            <a:xfrm>
              <a:off x="1288854" y="4805054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6.4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6064290" y="4850645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7.7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904893" y="4816778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6.6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428187" y="4850024"/>
              <a:ext cx="10205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8.4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24" name="Straight Arrow Connector 15"/>
          <p:cNvCxnSpPr/>
          <p:nvPr/>
        </p:nvCxnSpPr>
        <p:spPr>
          <a:xfrm flipV="1">
            <a:off x="399257" y="3944869"/>
            <a:ext cx="5862" cy="72021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 rot="16200000">
            <a:off x="-48706" y="4750897"/>
            <a:ext cx="8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pic>
        <p:nvPicPr>
          <p:cNvPr id="137" name="Picture 2" descr="C:\Users\zhanghongji\Desktop\KIDNEY_KIDNEY SHAM-1.fcs_Lymphocytes_Single Cells_FSC-A, Comp-APC-Cy7-A subset_FSC-A, Comp-PE-Cy7-G-A subset.png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570" y="3663957"/>
            <a:ext cx="1808781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8" name="Picture 3" descr="C:\Users\zhanghongji\Desktop\KIDNEY_KIDNEY  IR 6 +DNASE A.fcs_Lymphocytes_Single Cells_FSC-A, Comp-APC-Cy7-A subset_FSC-A, Comp-PE-Cy7-G-A subset.png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44570" y="3663957"/>
            <a:ext cx="180878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9" name="Picture 5" descr="C:\Users\zhanghongji\Desktop\KIDNEY_KIDNEY  IR 24.fcs_Lymphocytes_Single Cells_FSC-A, Comp-APC-Cy7-A subset_FSC-A, Comp-PE-Cy7-G-A subset.png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0570" y="3663957"/>
            <a:ext cx="180878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0" name="Picture 8" descr="C:\Users\zhanghongji\Desktop\KIDNEY_KIDNEY  IR24+DNASE A.fcs_Lymphocytes_Single Cells_FSC-A, Comp-APC-Cy7-A subset_FSC-A, Comp-PE-Cy7-G-A subset.png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2570" y="3663957"/>
            <a:ext cx="180878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1" name="TextBox 140"/>
          <p:cNvSpPr txBox="1"/>
          <p:nvPr/>
        </p:nvSpPr>
        <p:spPr>
          <a:xfrm>
            <a:off x="1325424" y="4688321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.2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6100860" y="4725445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0.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2941463" y="470004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4464757" y="4733291"/>
            <a:ext cx="1020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4.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-16228" y="497530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660278" y="5261101"/>
            <a:ext cx="883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940" y="4537075"/>
            <a:ext cx="374650" cy="69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0070" y="5347099"/>
            <a:ext cx="412750" cy="120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9" name="Picture 3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4359" y="5370827"/>
            <a:ext cx="412750" cy="120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0" name="Picture 3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8382" y="5370827"/>
            <a:ext cx="412750" cy="120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1" name="Picture 3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7300" y="5374677"/>
            <a:ext cx="412750" cy="120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2" name="TextBox 111"/>
          <p:cNvSpPr txBox="1"/>
          <p:nvPr/>
        </p:nvSpPr>
        <p:spPr>
          <a:xfrm>
            <a:off x="5908398" y="520540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4341365" y="520540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2h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851129" y="5195461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179656" y="5178226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2" name="组合 191"/>
          <p:cNvGrpSpPr/>
          <p:nvPr/>
        </p:nvGrpSpPr>
        <p:grpSpPr>
          <a:xfrm rot="5400000">
            <a:off x="1401430" y="6360162"/>
            <a:ext cx="3652710" cy="1869585"/>
            <a:chOff x="-4239827" y="3752695"/>
            <a:chExt cx="3652710" cy="1869585"/>
          </a:xfrm>
        </p:grpSpPr>
        <p:pic>
          <p:nvPicPr>
            <p:cNvPr id="193" name="Picture 16" descr="H:\4.IF.12.2019\74LM69 Julie Gowsami-Tsung\LG\after talking with Hai\LG6_blue-nuclei_green-cd41_red-cith3_white-actin_20x2z_3x3 400x400 25um bar.tif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4187117" y="3752695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4" name="Picture 17" descr="H:\4.IF.12.2019\74LM69 Julie Gowsami-Tsung\LG\after talking with Hai\LG6_blue-nuclei_green-cd41_red-cith3_white-actin_20x2z_3x3 200x200 25um bar.tif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387117" y="3752695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5" name="TextBox 194"/>
            <p:cNvSpPr txBox="1"/>
            <p:nvPr/>
          </p:nvSpPr>
          <p:spPr>
            <a:xfrm rot="16200000">
              <a:off x="-4738361" y="4785192"/>
              <a:ext cx="1335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ng  sham</a:t>
              </a:r>
              <a:endParaRPr lang="zh-CN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矩形 195"/>
            <p:cNvSpPr/>
            <p:nvPr/>
          </p:nvSpPr>
          <p:spPr>
            <a:xfrm>
              <a:off x="-3630650" y="4297940"/>
              <a:ext cx="943664" cy="969718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7" name="直接连接符 196"/>
            <p:cNvCxnSpPr/>
            <p:nvPr/>
          </p:nvCxnSpPr>
          <p:spPr>
            <a:xfrm rot="16200000">
              <a:off x="-1874765" y="3010293"/>
              <a:ext cx="475428" cy="2099869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直接连接符 197"/>
            <p:cNvCxnSpPr/>
            <p:nvPr/>
          </p:nvCxnSpPr>
          <p:spPr>
            <a:xfrm>
              <a:off x="-2686986" y="5267658"/>
              <a:ext cx="2099869" cy="216727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直接连接符 198"/>
            <p:cNvCxnSpPr/>
            <p:nvPr/>
          </p:nvCxnSpPr>
          <p:spPr>
            <a:xfrm>
              <a:off x="-3630650" y="5267658"/>
              <a:ext cx="1243533" cy="216727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直接连接符 199"/>
            <p:cNvCxnSpPr/>
            <p:nvPr/>
          </p:nvCxnSpPr>
          <p:spPr>
            <a:xfrm flipV="1">
              <a:off x="-3630650" y="3752695"/>
              <a:ext cx="1243533" cy="545246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0" name="组合 209"/>
          <p:cNvGrpSpPr/>
          <p:nvPr/>
        </p:nvGrpSpPr>
        <p:grpSpPr>
          <a:xfrm rot="5400000">
            <a:off x="3202965" y="6359749"/>
            <a:ext cx="3657579" cy="1877991"/>
            <a:chOff x="-4244696" y="5552695"/>
            <a:chExt cx="3657579" cy="1877991"/>
          </a:xfrm>
        </p:grpSpPr>
        <p:pic>
          <p:nvPicPr>
            <p:cNvPr id="211" name="Picture 22" descr="H:\4.IF.12.2019\74LM69 Julie Gowsami-Tsung\KD\after talking with hai\KD8_blue-nuclei_green-cd41_red-cith3_white-actin_20x2z_3x3 zoom 400x400 254um bar.tif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4187117" y="5552695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2" name="Picture 23" descr="H:\4.IF.12.2019\74LM69 Julie Gowsami-Tsung\KD\after talking with hai\KD8_blue-nuclei_green-cd41_red-cith3_white-actin_20x2z_3x3 zoom 200x200 254um bar.tif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387117" y="5552695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3" name="TextBox 212"/>
            <p:cNvSpPr txBox="1"/>
            <p:nvPr/>
          </p:nvSpPr>
          <p:spPr>
            <a:xfrm rot="16200000">
              <a:off x="-4805747" y="6531081"/>
              <a:ext cx="1460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dney sham</a:t>
              </a:r>
              <a:endParaRPr lang="zh-CN" altLang="en-US" sz="2000" b="1" u="sng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矩形 213"/>
            <p:cNvSpPr/>
            <p:nvPr/>
          </p:nvSpPr>
          <p:spPr>
            <a:xfrm>
              <a:off x="-3603975" y="5749071"/>
              <a:ext cx="943664" cy="969718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5" name="直接连接符 214"/>
            <p:cNvCxnSpPr/>
            <p:nvPr/>
          </p:nvCxnSpPr>
          <p:spPr>
            <a:xfrm rot="16200000">
              <a:off x="-1751482" y="4708179"/>
              <a:ext cx="132063" cy="1949720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直接连接符 215"/>
            <p:cNvCxnSpPr/>
            <p:nvPr/>
          </p:nvCxnSpPr>
          <p:spPr>
            <a:xfrm>
              <a:off x="-2660311" y="6714015"/>
              <a:ext cx="1949717" cy="597403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直接连接符 216"/>
            <p:cNvCxnSpPr/>
            <p:nvPr/>
          </p:nvCxnSpPr>
          <p:spPr>
            <a:xfrm>
              <a:off x="-3603975" y="6718789"/>
              <a:ext cx="1216858" cy="592629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直接连接符 217"/>
            <p:cNvCxnSpPr/>
            <p:nvPr/>
          </p:nvCxnSpPr>
          <p:spPr>
            <a:xfrm rot="16200000">
              <a:off x="-3064690" y="5077722"/>
              <a:ext cx="132064" cy="1210634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9" name="组合 218"/>
          <p:cNvGrpSpPr/>
          <p:nvPr/>
        </p:nvGrpSpPr>
        <p:grpSpPr>
          <a:xfrm rot="5400000">
            <a:off x="-426200" y="6359530"/>
            <a:ext cx="3670004" cy="1886328"/>
            <a:chOff x="-4257121" y="1942756"/>
            <a:chExt cx="3670004" cy="1886328"/>
          </a:xfrm>
        </p:grpSpPr>
        <p:pic>
          <p:nvPicPr>
            <p:cNvPr id="220" name="Picture 18" descr="H:\4.IF.12.2019\74LM69 Julie Gowsami-Tsung\LV\after talking with Hai\LV6_blue-nuclei_green-cd41_red-cith3_white-actin_20x2z_3x3 400x400 25um bar.tif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4187117" y="1951028"/>
              <a:ext cx="1785600" cy="1785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1" name="Picture 19" descr="H:\4.IF.12.2019\74LM69 Julie Gowsami-Tsung\LV\after talking with Hai\LV6_blue-nuclei_green-cd41_red-cith3_white-actin_20x2z_3x3 200x200 25um bar.tif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397056" y="1942756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2" name="TextBox 221"/>
            <p:cNvSpPr txBox="1"/>
            <p:nvPr/>
          </p:nvSpPr>
          <p:spPr>
            <a:xfrm rot="16200000">
              <a:off x="-4721992" y="3025659"/>
              <a:ext cx="12682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ver sham</a:t>
              </a:r>
              <a:endParaRPr lang="zh-CN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3" name="直接连接符 222"/>
            <p:cNvCxnSpPr/>
            <p:nvPr/>
          </p:nvCxnSpPr>
          <p:spPr>
            <a:xfrm flipV="1">
              <a:off x="-2893748" y="1967292"/>
              <a:ext cx="2306631" cy="713534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直接连接符 223"/>
            <p:cNvCxnSpPr/>
            <p:nvPr/>
          </p:nvCxnSpPr>
          <p:spPr>
            <a:xfrm>
              <a:off x="-2893748" y="3656690"/>
              <a:ext cx="2306631" cy="45904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直接连接符 224"/>
            <p:cNvCxnSpPr/>
            <p:nvPr/>
          </p:nvCxnSpPr>
          <p:spPr>
            <a:xfrm>
              <a:off x="-3837412" y="3610787"/>
              <a:ext cx="1450295" cy="91807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直接连接符 225"/>
            <p:cNvCxnSpPr/>
            <p:nvPr/>
          </p:nvCxnSpPr>
          <p:spPr>
            <a:xfrm flipV="1">
              <a:off x="-3837412" y="2007045"/>
              <a:ext cx="1450295" cy="673780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矩形 226"/>
            <p:cNvSpPr/>
            <p:nvPr/>
          </p:nvSpPr>
          <p:spPr>
            <a:xfrm>
              <a:off x="-3837412" y="2680824"/>
              <a:ext cx="943664" cy="969718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28" name="Straight Arrow Connector 31"/>
          <p:cNvCxnSpPr/>
          <p:nvPr/>
        </p:nvCxnSpPr>
        <p:spPr>
          <a:xfrm>
            <a:off x="1168174" y="5436036"/>
            <a:ext cx="83205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9" name="TextBox 228"/>
          <p:cNvSpPr txBox="1"/>
          <p:nvPr/>
        </p:nvSpPr>
        <p:spPr>
          <a:xfrm>
            <a:off x="57939" y="5329067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5" name="矩形 74"/>
          <p:cNvSpPr/>
          <p:nvPr/>
        </p:nvSpPr>
        <p:spPr>
          <a:xfrm>
            <a:off x="5962605" y="8038486"/>
            <a:ext cx="720069" cy="10772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n-US" altLang="zh-CN" sz="16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  <a:p>
            <a:r>
              <a:rPr lang="en-US" altLang="zh-CN" sz="16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1</a:t>
            </a:r>
          </a:p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-H3</a:t>
            </a:r>
            <a:endParaRPr lang="zh-CN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131">
            <a:extLst>
              <a:ext uri="{FF2B5EF4-FFF2-40B4-BE49-F238E27FC236}">
                <a16:creationId xmlns:a16="http://schemas.microsoft.com/office/drawing/2014/main" id="{D764611F-80CD-4A8C-AC6A-AC0B9C43BB7F}"/>
              </a:ext>
            </a:extLst>
          </p:cNvPr>
          <p:cNvSpPr txBox="1"/>
          <p:nvPr/>
        </p:nvSpPr>
        <p:spPr>
          <a:xfrm>
            <a:off x="-234929" y="3676726"/>
            <a:ext cx="110872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62717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-227281" y="505537"/>
            <a:ext cx="67239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-212323" y="6266800"/>
            <a:ext cx="67239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8916" y="2725116"/>
            <a:ext cx="1870000" cy="153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2520" y="4364890"/>
            <a:ext cx="1841667" cy="153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5909" y="1174455"/>
            <a:ext cx="1827500" cy="153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3312" y="737390"/>
            <a:ext cx="739862" cy="43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6" name="组合 5">
            <a:extLst>
              <a:ext uri="{FF2B5EF4-FFF2-40B4-BE49-F238E27FC236}">
                <a16:creationId xmlns:a16="http://schemas.microsoft.com/office/drawing/2014/main" id="{BF5FD7F0-BEDB-4D1F-A3C2-1DED238613D9}"/>
              </a:ext>
            </a:extLst>
          </p:cNvPr>
          <p:cNvGrpSpPr/>
          <p:nvPr/>
        </p:nvGrpSpPr>
        <p:grpSpPr>
          <a:xfrm>
            <a:off x="147145" y="6256340"/>
            <a:ext cx="6405847" cy="3128884"/>
            <a:chOff x="-7743300" y="5371897"/>
            <a:chExt cx="6405847" cy="3128884"/>
          </a:xfrm>
        </p:grpSpPr>
        <p:grpSp>
          <p:nvGrpSpPr>
            <p:cNvPr id="5" name="组合 4"/>
            <p:cNvGrpSpPr/>
            <p:nvPr/>
          </p:nvGrpSpPr>
          <p:grpSpPr>
            <a:xfrm>
              <a:off x="-7743300" y="5371897"/>
              <a:ext cx="6405847" cy="2315133"/>
              <a:chOff x="328529" y="6946355"/>
              <a:chExt cx="6405847" cy="2315133"/>
            </a:xfrm>
          </p:grpSpPr>
          <p:pic>
            <p:nvPicPr>
              <p:cNvPr id="43" name="Picture 3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25448" y="7396110"/>
                <a:ext cx="4173766" cy="37399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4" name="Picture 4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25448" y="8190493"/>
                <a:ext cx="4173766" cy="38356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9" name="Picture 6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25448" y="7786577"/>
                <a:ext cx="4173766" cy="2544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0" name="Picture 7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25448" y="8599691"/>
                <a:ext cx="4173766" cy="3624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1" name="TextBox 50"/>
              <p:cNvSpPr txBox="1"/>
              <p:nvPr/>
            </p:nvSpPr>
            <p:spPr>
              <a:xfrm>
                <a:off x="1005072" y="6946355"/>
                <a:ext cx="5140690" cy="600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Sham        </a:t>
                </a:r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6h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6h</a:t>
                </a:r>
                <a:r>
                  <a:rPr lang="en-US" altLang="zh-CN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+DNase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12h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12h</a:t>
                </a:r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+DNase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24h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24h</a:t>
                </a:r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DNase</a:t>
                </a:r>
              </a:p>
              <a:p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5340203" y="7277021"/>
                <a:ext cx="1180231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</a:p>
              <a:p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it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H3:</a:t>
                </a:r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KD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:43KD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445806" y="7556061"/>
                <a:ext cx="63991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ung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28529" y="8434938"/>
                <a:ext cx="80983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Kidney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142565" y="8153492"/>
                <a:ext cx="1591811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</a:p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it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H3:</a:t>
                </a:r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KD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Actin:43KD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0" name="Picture 2">
              <a:extLst>
                <a:ext uri="{FF2B5EF4-FFF2-40B4-BE49-F238E27FC236}">
                  <a16:creationId xmlns:a16="http://schemas.microsoft.com/office/drawing/2014/main" id="{CFFDFD9D-57F9-445C-867F-EA984C4EB09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6853697" y="7492406"/>
              <a:ext cx="4173767" cy="35170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1" name="Picture 5">
              <a:extLst>
                <a:ext uri="{FF2B5EF4-FFF2-40B4-BE49-F238E27FC236}">
                  <a16:creationId xmlns:a16="http://schemas.microsoft.com/office/drawing/2014/main" id="{345EE513-F788-4E6D-BD18-79EDA2732E9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6854915" y="7861486"/>
              <a:ext cx="4173767" cy="32083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2" name="TextBox 52">
              <a:extLst>
                <a:ext uri="{FF2B5EF4-FFF2-40B4-BE49-F238E27FC236}">
                  <a16:creationId xmlns:a16="http://schemas.microsoft.com/office/drawing/2014/main" id="{80A7281F-96C9-41D5-8EF9-3EDEE557C522}"/>
                </a:ext>
              </a:extLst>
            </p:cNvPr>
            <p:cNvSpPr txBox="1"/>
            <p:nvPr/>
          </p:nvSpPr>
          <p:spPr>
            <a:xfrm>
              <a:off x="-7626023" y="7677978"/>
              <a:ext cx="6286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57">
              <a:extLst>
                <a:ext uri="{FF2B5EF4-FFF2-40B4-BE49-F238E27FC236}">
                  <a16:creationId xmlns:a16="http://schemas.microsoft.com/office/drawing/2014/main" id="{262CC9E4-B317-42C9-B19D-DFEB73A26925}"/>
                </a:ext>
              </a:extLst>
            </p:cNvPr>
            <p:cNvSpPr txBox="1"/>
            <p:nvPr/>
          </p:nvSpPr>
          <p:spPr>
            <a:xfrm>
              <a:off x="-2735293" y="7392785"/>
              <a:ext cx="1180231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</a:p>
            <a:p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it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H3:</a:t>
              </a:r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5KD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ctin:43KD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B6819310-0407-416D-B032-9C0970693187}"/>
              </a:ext>
            </a:extLst>
          </p:cNvPr>
          <p:cNvGrpSpPr/>
          <p:nvPr/>
        </p:nvGrpSpPr>
        <p:grpSpPr>
          <a:xfrm>
            <a:off x="0" y="846108"/>
            <a:ext cx="5310262" cy="5463698"/>
            <a:chOff x="-6713658" y="1153885"/>
            <a:chExt cx="5310262" cy="5463698"/>
          </a:xfrm>
        </p:grpSpPr>
        <p:grpSp>
          <p:nvGrpSpPr>
            <p:cNvPr id="4" name="组合 3"/>
            <p:cNvGrpSpPr/>
            <p:nvPr/>
          </p:nvGrpSpPr>
          <p:grpSpPr>
            <a:xfrm>
              <a:off x="-6713658" y="1153885"/>
              <a:ext cx="5310262" cy="5463698"/>
              <a:chOff x="-70216" y="619200"/>
              <a:chExt cx="5310262" cy="5463698"/>
            </a:xfrm>
          </p:grpSpPr>
          <p:cxnSp>
            <p:nvCxnSpPr>
              <p:cNvPr id="75" name="Straight Arrow Connector 15"/>
              <p:cNvCxnSpPr/>
              <p:nvPr/>
            </p:nvCxnSpPr>
            <p:spPr>
              <a:xfrm flipV="1">
                <a:off x="84306" y="4421055"/>
                <a:ext cx="0" cy="68936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Arrow Connector 31"/>
              <p:cNvCxnSpPr/>
              <p:nvPr/>
            </p:nvCxnSpPr>
            <p:spPr>
              <a:xfrm>
                <a:off x="793772" y="5959787"/>
                <a:ext cx="100706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TextBox 76"/>
              <p:cNvSpPr txBox="1"/>
              <p:nvPr/>
            </p:nvSpPr>
            <p:spPr>
              <a:xfrm>
                <a:off x="294686" y="5775121"/>
                <a:ext cx="791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Y6G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 rot="16200000">
                <a:off x="-358165" y="5167632"/>
                <a:ext cx="8836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  <p:grpSp>
            <p:nvGrpSpPr>
              <p:cNvPr id="3" name="组合 2"/>
              <p:cNvGrpSpPr/>
              <p:nvPr/>
            </p:nvGrpSpPr>
            <p:grpSpPr>
              <a:xfrm>
                <a:off x="44610" y="619200"/>
                <a:ext cx="5195436" cy="1821563"/>
                <a:chOff x="750225" y="1851469"/>
                <a:chExt cx="5195436" cy="1821563"/>
              </a:xfrm>
            </p:grpSpPr>
            <p:pic>
              <p:nvPicPr>
                <p:cNvPr id="94" name="Picture 7" descr="C:\Users\zhanghongji\Desktop\lung\neu\lung_lung IR 6 DNASE A.fcs_Lymphocytes_Single Cells_FSC-A, Comp-APC-Cy7-A subset_FSC-A, Comp-PE-Cy7-G-A subset1.png"/>
                <p:cNvPicPr>
                  <a:picLocks noChangeAspect="1" noChangeArrowheads="1"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918225" y="1873032"/>
                  <a:ext cx="1808780" cy="180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95" name="Picture 9" descr="C:\Users\zhanghongji\Desktop\lung\neu\lung_lung IR 12.fcs_Lymphocytes_Single Cells_FSC-A, Comp-APC-Cy7-A subset_FSC-A, Comp-PE-Cy7-G-A subset1.png"/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50225" y="1851469"/>
                  <a:ext cx="1808780" cy="180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96" name="Picture 13" descr="C:\Users\zhanghongji\Desktop\lung\neu\lung_lung IR24+DNASE A.fcs_Lymphocytes_Single Cells_FSC-A, Comp-APC-Cy7-A subset_FSC-A, Comp-PE-Cy7-G-A subset1.png"/>
                <p:cNvPicPr>
                  <a:picLocks noChangeAspect="1" noChangeArrowheads="1"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332530" y="1860706"/>
                  <a:ext cx="1808780" cy="180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03" name="TextBox 102"/>
                <p:cNvSpPr txBox="1"/>
                <p:nvPr/>
              </p:nvSpPr>
              <p:spPr>
                <a:xfrm>
                  <a:off x="1812269" y="2902349"/>
                  <a:ext cx="63350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.8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3453108" y="2886851"/>
                  <a:ext cx="44114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4925073" y="2905811"/>
                  <a:ext cx="102058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4.7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97" name="Picture 6" descr="C:\Users\zhanghongji\Desktop\KIDNEY_KIDNEY  IR12+DNASE A.fcs_Lymphocytes_Single Cells_FSC-A, Comp-APC-Cy7-A subset_FSC-A, Comp-PE-Cy7-G-A subset.png"/>
              <p:cNvPicPr>
                <a:picLocks noChangeAspect="1"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28610" y="2347200"/>
                <a:ext cx="180878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8" name="Picture 7" descr="C:\Users\zhanghongji\Desktop\KIDNEY_KIDNEY  IR12+DNASE B.fcs_Lymphocytes_Single Cells_FSC-A, Comp-APC-Cy7-A subset_FSC-A, Comp-PE-Cy7-G-A subset.png"/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12610" y="2347200"/>
                <a:ext cx="180878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9" name="Picture 11" descr="C:\Users\zhanghongji\Desktop\KIDNEY_KIDNEY SHAM-2.fcs_Lymphocytes_Single Cells_FSC-A, Comp-APC-Cy7-A subset_FSC-A, Comp-PE-Cy7-G-A subset.png"/>
              <p:cNvPicPr>
                <a:picLocks noChangeAspect="1" noChangeArrowheads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610" y="2338733"/>
                <a:ext cx="1808780" cy="180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06" name="TextBox 105"/>
              <p:cNvSpPr txBox="1"/>
              <p:nvPr/>
            </p:nvSpPr>
            <p:spPr>
              <a:xfrm>
                <a:off x="1025985" y="3524137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9.14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2666824" y="3524137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12.8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93533" y="5859159"/>
                <a:ext cx="361950" cy="69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3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50227" y="5848269"/>
                <a:ext cx="361950" cy="69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4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39579" y="5870037"/>
                <a:ext cx="361950" cy="69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5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04415" y="4128281"/>
                <a:ext cx="361950" cy="69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6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82881" y="4128277"/>
                <a:ext cx="361950" cy="69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7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72233" y="4139159"/>
                <a:ext cx="361950" cy="69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8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4658" y="2384455"/>
                <a:ext cx="429045" cy="8279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9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39762" y="2373982"/>
                <a:ext cx="483293" cy="9326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0" name="Picture 2"/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872726" y="2384868"/>
                <a:ext cx="539681" cy="1041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1" name="TextBox 70"/>
              <p:cNvSpPr txBox="1"/>
              <p:nvPr/>
            </p:nvSpPr>
            <p:spPr>
              <a:xfrm>
                <a:off x="3792600" y="5737920"/>
                <a:ext cx="115448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h+DNase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2195586" y="5729790"/>
                <a:ext cx="115448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h+DNase</a:t>
                </a:r>
                <a:endParaRPr lang="zh-CN" alt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804658" y="5708399"/>
                <a:ext cx="10550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h+DNase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79" name="Picture 11" descr="C:\Users\zhanghongji\Desktop\Specimen_001_13_010.fcs_Lymphocytes_Single Cells_FSC-A, VIAB subset_FSC-A, CD45 subset.png">
              <a:extLst>
                <a:ext uri="{FF2B5EF4-FFF2-40B4-BE49-F238E27FC236}">
                  <a16:creationId xmlns:a16="http://schemas.microsoft.com/office/drawing/2014/main" id="{CDAA0A16-3F61-4FDB-A6BE-8F727464B14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3430832" y="4501083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0" name="Picture 12" descr="C:\Users\zhanghongji\Desktop\Specimen_001_9_014.fcs_Lymphocytes_Single Cells_FSC-A, VIAB subset_FSC-A, CD45 subset.png">
              <a:extLst>
                <a:ext uri="{FF2B5EF4-FFF2-40B4-BE49-F238E27FC236}">
                  <a16:creationId xmlns:a16="http://schemas.microsoft.com/office/drawing/2014/main" id="{D6A34F06-F973-4A9B-91F7-0DAD2F1C769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6598832" y="4500227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1" name="Picture 13" descr="C:\Users\zhanghongji\Desktop\Specimen_001_10_015.fcs_Lymphocytes_Single Cells_FSC-A, VIAB subset_FSC-A, CD45 subset.png">
              <a:extLst>
                <a:ext uri="{FF2B5EF4-FFF2-40B4-BE49-F238E27FC236}">
                  <a16:creationId xmlns:a16="http://schemas.microsoft.com/office/drawing/2014/main" id="{C5AF3BB9-A0AC-4151-8915-C1C876DF5F0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5014832" y="4501083"/>
              <a:ext cx="180878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2" name="TextBox 99">
              <a:extLst>
                <a:ext uri="{FF2B5EF4-FFF2-40B4-BE49-F238E27FC236}">
                  <a16:creationId xmlns:a16="http://schemas.microsoft.com/office/drawing/2014/main" id="{DE4B8AA6-EB07-4D8F-8BA2-897180537B87}"/>
                </a:ext>
              </a:extLst>
            </p:cNvPr>
            <p:cNvSpPr txBox="1"/>
            <p:nvPr/>
          </p:nvSpPr>
          <p:spPr>
            <a:xfrm>
              <a:off x="-5693946" y="5529427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6.44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100">
              <a:extLst>
                <a:ext uri="{FF2B5EF4-FFF2-40B4-BE49-F238E27FC236}">
                  <a16:creationId xmlns:a16="http://schemas.microsoft.com/office/drawing/2014/main" id="{BB51DF73-F35E-4595-83BA-E9F73BA8B467}"/>
                </a:ext>
              </a:extLst>
            </p:cNvPr>
            <p:cNvSpPr txBox="1"/>
            <p:nvPr/>
          </p:nvSpPr>
          <p:spPr>
            <a:xfrm>
              <a:off x="-4017938" y="5529427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.8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101">
              <a:extLst>
                <a:ext uri="{FF2B5EF4-FFF2-40B4-BE49-F238E27FC236}">
                  <a16:creationId xmlns:a16="http://schemas.microsoft.com/office/drawing/2014/main" id="{1EED7B08-7A63-462F-8106-1E287D80474A}"/>
                </a:ext>
              </a:extLst>
            </p:cNvPr>
            <p:cNvSpPr txBox="1"/>
            <p:nvPr/>
          </p:nvSpPr>
          <p:spPr>
            <a:xfrm>
              <a:off x="-2565644" y="5579383"/>
              <a:ext cx="10205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.09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107">
              <a:extLst>
                <a:ext uri="{FF2B5EF4-FFF2-40B4-BE49-F238E27FC236}">
                  <a16:creationId xmlns:a16="http://schemas.microsoft.com/office/drawing/2014/main" id="{6BE60688-4DCA-4ABE-BE5A-BBC0DD3F58D6}"/>
                </a:ext>
              </a:extLst>
            </p:cNvPr>
            <p:cNvSpPr txBox="1"/>
            <p:nvPr/>
          </p:nvSpPr>
          <p:spPr>
            <a:xfrm>
              <a:off x="-2423984" y="4049024"/>
              <a:ext cx="10205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6.82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039440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91440" y="18288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864498" y="16051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A72E2E48-2410-415B-BE81-BD1AED4007DA}"/>
              </a:ext>
            </a:extLst>
          </p:cNvPr>
          <p:cNvSpPr/>
          <p:nvPr/>
        </p:nvSpPr>
        <p:spPr>
          <a:xfrm>
            <a:off x="4082400" y="4546764"/>
            <a:ext cx="283763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1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7" descr="H:\4.IF.12.2019\77LM87 Julie CD41-gr Fibribogen-red\after talking with Hai\LIVER\1-2LV_blue-nuclei_green-CD41_red-fibrinogen_white-actin_20x2z_3x3-400X400 25UN BAR.tif">
            <a:extLst>
              <a:ext uri="{FF2B5EF4-FFF2-40B4-BE49-F238E27FC236}">
                <a16:creationId xmlns:a16="http://schemas.microsoft.com/office/drawing/2014/main" id="{E27A552E-A856-4E29-8ABC-FCC7AE86B37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9888" y="2984500"/>
            <a:ext cx="1325880" cy="13258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9" descr="H:\4.IF.12.2019\78LM16 Tsung - Julie\after talking with HAI\liver\LV1_blue-nuclei_red-fibrinogen_green-CD41_white-actin_20x2z_3x3 400X400 25UM BAR.tif">
            <a:extLst>
              <a:ext uri="{FF2B5EF4-FFF2-40B4-BE49-F238E27FC236}">
                <a16:creationId xmlns:a16="http://schemas.microsoft.com/office/drawing/2014/main" id="{496ED9A9-0965-4A66-A2B4-31D8A804FF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1488" y="2984500"/>
            <a:ext cx="1325880" cy="13258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B4AAB356-4420-4ADB-95C5-370C0A4B6B8F}"/>
              </a:ext>
            </a:extLst>
          </p:cNvPr>
          <p:cNvCxnSpPr/>
          <p:nvPr/>
        </p:nvCxnSpPr>
        <p:spPr>
          <a:xfrm flipH="1">
            <a:off x="1824975" y="3983285"/>
            <a:ext cx="263327" cy="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7855E0E6-2FC0-42C4-8B18-205E7BEBEDD8}"/>
              </a:ext>
            </a:extLst>
          </p:cNvPr>
          <p:cNvCxnSpPr/>
          <p:nvPr/>
        </p:nvCxnSpPr>
        <p:spPr>
          <a:xfrm flipH="1">
            <a:off x="2243961" y="3375899"/>
            <a:ext cx="263327" cy="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228">
            <a:extLst>
              <a:ext uri="{FF2B5EF4-FFF2-40B4-BE49-F238E27FC236}">
                <a16:creationId xmlns:a16="http://schemas.microsoft.com/office/drawing/2014/main" id="{A76A4CF1-8F98-4DB7-B6EB-FA8ED9D244D8}"/>
              </a:ext>
            </a:extLst>
          </p:cNvPr>
          <p:cNvSpPr txBox="1"/>
          <p:nvPr/>
        </p:nvSpPr>
        <p:spPr>
          <a:xfrm>
            <a:off x="5068888" y="19005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Box 228">
            <a:extLst>
              <a:ext uri="{FF2B5EF4-FFF2-40B4-BE49-F238E27FC236}">
                <a16:creationId xmlns:a16="http://schemas.microsoft.com/office/drawing/2014/main" id="{57F786C3-55AB-4173-8195-ADEA71CD0397}"/>
              </a:ext>
            </a:extLst>
          </p:cNvPr>
          <p:cNvSpPr txBox="1"/>
          <p:nvPr/>
        </p:nvSpPr>
        <p:spPr>
          <a:xfrm>
            <a:off x="-15125" y="2263590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DAE3F0BC-2E43-4B9F-B6DD-060330426DF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33088" y="2984500"/>
            <a:ext cx="1325880" cy="1325880"/>
          </a:xfrm>
          <a:prstGeom prst="rect">
            <a:avLst/>
          </a:prstGeom>
        </p:spPr>
      </p:pic>
      <p:graphicFrame>
        <p:nvGraphicFramePr>
          <p:cNvPr id="23" name="对象 22">
            <a:extLst>
              <a:ext uri="{FF2B5EF4-FFF2-40B4-BE49-F238E27FC236}">
                <a16:creationId xmlns:a16="http://schemas.microsoft.com/office/drawing/2014/main" id="{8AE2E711-A214-4652-8F64-5634862915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0430969"/>
              </p:ext>
            </p:extLst>
          </p:nvPr>
        </p:nvGraphicFramePr>
        <p:xfrm>
          <a:off x="21441" y="350621"/>
          <a:ext cx="2002509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49" name="Prism Project" r:id="rId10" imgW="3384000" imgH="2628000" progId="Prism5.Document">
                  <p:embed/>
                </p:oleObj>
              </mc:Choice>
              <mc:Fallback>
                <p:oleObj name="Prism Project" r:id="rId10" imgW="3384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441" y="350621"/>
                        <a:ext cx="2002509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>
            <a:extLst>
              <a:ext uri="{FF2B5EF4-FFF2-40B4-BE49-F238E27FC236}">
                <a16:creationId xmlns:a16="http://schemas.microsoft.com/office/drawing/2014/main" id="{D440698C-D737-4A97-B9BD-12C6CD1878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0681288"/>
              </p:ext>
            </p:extLst>
          </p:nvPr>
        </p:nvGraphicFramePr>
        <p:xfrm>
          <a:off x="4983163" y="269875"/>
          <a:ext cx="1976437" cy="1554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0" name="Prism Project" r:id="rId12" imgW="3708000" imgH="2916000" progId="Prism5.Document">
                  <p:embed/>
                </p:oleObj>
              </mc:Choice>
              <mc:Fallback>
                <p:oleObj name="Prism Project" r:id="rId12" imgW="3708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983163" y="269875"/>
                        <a:ext cx="1976437" cy="1554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>
            <a:extLst>
              <a:ext uri="{FF2B5EF4-FFF2-40B4-BE49-F238E27FC236}">
                <a16:creationId xmlns:a16="http://schemas.microsoft.com/office/drawing/2014/main" id="{CED1A92E-6471-4DD9-BCDA-A679FA4667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5356466"/>
              </p:ext>
            </p:extLst>
          </p:nvPr>
        </p:nvGraphicFramePr>
        <p:xfrm>
          <a:off x="1864498" y="289486"/>
          <a:ext cx="1861653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1" name="Prism Project" r:id="rId14" imgW="3492000" imgH="2916000" progId="Prism5.Document">
                  <p:embed/>
                </p:oleObj>
              </mc:Choice>
              <mc:Fallback>
                <p:oleObj name="Prism Project" r:id="rId14" imgW="3492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864498" y="289486"/>
                        <a:ext cx="1861653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对象 25">
            <a:extLst>
              <a:ext uri="{FF2B5EF4-FFF2-40B4-BE49-F238E27FC236}">
                <a16:creationId xmlns:a16="http://schemas.microsoft.com/office/drawing/2014/main" id="{9A04BEF6-8419-4287-8B75-033BC08E20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4150861"/>
              </p:ext>
            </p:extLst>
          </p:nvPr>
        </p:nvGraphicFramePr>
        <p:xfrm>
          <a:off x="3515735" y="291449"/>
          <a:ext cx="1842190" cy="1554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2" name="Prism Project" r:id="rId16" imgW="3456000" imgH="2916000" progId="Prism5.Document">
                  <p:embed/>
                </p:oleObj>
              </mc:Choice>
              <mc:Fallback>
                <p:oleObj name="Prism Project" r:id="rId16" imgW="3456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515735" y="291449"/>
                        <a:ext cx="1842190" cy="1554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0" name="图片 39">
            <a:extLst>
              <a:ext uri="{FF2B5EF4-FFF2-40B4-BE49-F238E27FC236}">
                <a16:creationId xmlns:a16="http://schemas.microsoft.com/office/drawing/2014/main" id="{916DD736-885F-4385-A037-A467FFCD56E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68565" y="71544"/>
            <a:ext cx="947878" cy="640080"/>
          </a:xfrm>
          <a:prstGeom prst="rect">
            <a:avLst/>
          </a:prstGeom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68F32FA0-41E4-4930-8BAD-83FC7DB3C316}"/>
              </a:ext>
            </a:extLst>
          </p:cNvPr>
          <p:cNvSpPr/>
          <p:nvPr/>
        </p:nvSpPr>
        <p:spPr>
          <a:xfrm>
            <a:off x="2921250" y="2681176"/>
            <a:ext cx="9973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4h+DNase</a:t>
            </a: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0E41BD24-8DAD-4850-97C6-AAE104730696}"/>
              </a:ext>
            </a:extLst>
          </p:cNvPr>
          <p:cNvSpPr/>
          <p:nvPr/>
        </p:nvSpPr>
        <p:spPr>
          <a:xfrm>
            <a:off x="1554480" y="2643410"/>
            <a:ext cx="8969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24h+NET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EADA51FA-B2F9-4930-8426-2849564AE5E7}"/>
              </a:ext>
            </a:extLst>
          </p:cNvPr>
          <p:cNvSpPr/>
          <p:nvPr/>
        </p:nvSpPr>
        <p:spPr>
          <a:xfrm>
            <a:off x="4151376" y="2667268"/>
            <a:ext cx="113826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AD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95">
            <a:extLst>
              <a:ext uri="{FF2B5EF4-FFF2-40B4-BE49-F238E27FC236}">
                <a16:creationId xmlns:a16="http://schemas.microsoft.com/office/drawing/2014/main" id="{1F5EC0FA-8F08-459D-B9CD-5D9CE6F75F17}"/>
              </a:ext>
            </a:extLst>
          </p:cNvPr>
          <p:cNvSpPr txBox="1"/>
          <p:nvPr/>
        </p:nvSpPr>
        <p:spPr>
          <a:xfrm>
            <a:off x="5267313" y="2667762"/>
            <a:ext cx="176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solidFill>
                  <a:srgbClr val="24213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4</a:t>
            </a:r>
            <a:r>
              <a:rPr lang="en-US" sz="1200" dirty="0">
                <a:solidFill>
                  <a:srgbClr val="24213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solidFill>
                  <a:srgbClr val="24213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O+NETs</a:t>
            </a:r>
            <a:r>
              <a:rPr lang="en-US" sz="1200" dirty="0">
                <a:solidFill>
                  <a:srgbClr val="24213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solidFill>
                  <a:srgbClr val="24213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1200" dirty="0">
              <a:solidFill>
                <a:srgbClr val="24213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94">
            <a:extLst>
              <a:ext uri="{FF2B5EF4-FFF2-40B4-BE49-F238E27FC236}">
                <a16:creationId xmlns:a16="http://schemas.microsoft.com/office/drawing/2014/main" id="{24EBA668-E588-4DCB-8192-5E8A95724BD9}"/>
              </a:ext>
            </a:extLst>
          </p:cNvPr>
          <p:cNvSpPr txBox="1"/>
          <p:nvPr/>
        </p:nvSpPr>
        <p:spPr>
          <a:xfrm>
            <a:off x="64008" y="2640330"/>
            <a:ext cx="10901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solidFill>
                  <a:srgbClr val="24213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h+PBS</a:t>
            </a:r>
            <a:endParaRPr lang="en-US" sz="1200" dirty="0">
              <a:solidFill>
                <a:srgbClr val="24213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C18BEBA7-2E11-4ADE-BE12-E0A7B4D051B2}"/>
              </a:ext>
            </a:extLst>
          </p:cNvPr>
          <p:cNvSpPr/>
          <p:nvPr/>
        </p:nvSpPr>
        <p:spPr>
          <a:xfrm>
            <a:off x="3175329" y="2470906"/>
            <a:ext cx="5164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AE12B426-3DD2-462A-94C1-51CED3E914C1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288" y="2984500"/>
            <a:ext cx="1325880" cy="132588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68AEC4B1-CF30-45AB-835E-E6D3693F0CA8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501218" y="2984500"/>
            <a:ext cx="1325880" cy="1325880"/>
          </a:xfrm>
          <a:prstGeom prst="rect">
            <a:avLst/>
          </a:prstGeom>
        </p:spPr>
      </p:pic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9F9510FC-AE9B-4DD9-9A05-D120C5A9EB87}"/>
              </a:ext>
            </a:extLst>
          </p:cNvPr>
          <p:cNvCxnSpPr/>
          <p:nvPr/>
        </p:nvCxnSpPr>
        <p:spPr>
          <a:xfrm flipH="1">
            <a:off x="322012" y="3145085"/>
            <a:ext cx="263327" cy="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2335F54A-557E-4CC7-BEC9-4F6645BC8663}"/>
              </a:ext>
            </a:extLst>
          </p:cNvPr>
          <p:cNvCxnSpPr/>
          <p:nvPr/>
        </p:nvCxnSpPr>
        <p:spPr>
          <a:xfrm flipH="1">
            <a:off x="681228" y="3737849"/>
            <a:ext cx="263327" cy="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23E906CB-4052-4BD9-A408-7804FBDB6020}"/>
              </a:ext>
            </a:extLst>
          </p:cNvPr>
          <p:cNvCxnSpPr/>
          <p:nvPr/>
        </p:nvCxnSpPr>
        <p:spPr>
          <a:xfrm flipH="1">
            <a:off x="6421628" y="3229849"/>
            <a:ext cx="263327" cy="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DE12B399-9607-41FF-A657-8B40964AB67E}"/>
              </a:ext>
            </a:extLst>
          </p:cNvPr>
          <p:cNvCxnSpPr/>
          <p:nvPr/>
        </p:nvCxnSpPr>
        <p:spPr>
          <a:xfrm flipH="1">
            <a:off x="5596128" y="4169649"/>
            <a:ext cx="263327" cy="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351043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TextBox 74">
            <a:extLst>
              <a:ext uri="{FF2B5EF4-FFF2-40B4-BE49-F238E27FC236}">
                <a16:creationId xmlns:a16="http://schemas.microsoft.com/office/drawing/2014/main" id="{0E31F53D-1A27-4022-9DFE-511E588B56E1}"/>
              </a:ext>
            </a:extLst>
          </p:cNvPr>
          <p:cNvSpPr txBox="1"/>
          <p:nvPr/>
        </p:nvSpPr>
        <p:spPr>
          <a:xfrm>
            <a:off x="2461500" y="470552"/>
            <a:ext cx="251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2" name="TextBox 74">
            <a:extLst>
              <a:ext uri="{FF2B5EF4-FFF2-40B4-BE49-F238E27FC236}">
                <a16:creationId xmlns:a16="http://schemas.microsoft.com/office/drawing/2014/main" id="{ECEA7AD7-392B-489B-81C2-3BB3445B6D57}"/>
              </a:ext>
            </a:extLst>
          </p:cNvPr>
          <p:cNvSpPr txBox="1"/>
          <p:nvPr/>
        </p:nvSpPr>
        <p:spPr>
          <a:xfrm>
            <a:off x="91440" y="470552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21" name="图片 120">
            <a:extLst>
              <a:ext uri="{FF2B5EF4-FFF2-40B4-BE49-F238E27FC236}">
                <a16:creationId xmlns:a16="http://schemas.microsoft.com/office/drawing/2014/main" id="{8D29A2E6-2A17-4311-95B5-38AF670270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2874" y="647726"/>
            <a:ext cx="1366177" cy="722957"/>
          </a:xfrm>
          <a:prstGeom prst="rect">
            <a:avLst/>
          </a:prstGeom>
        </p:spPr>
      </p:pic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DAF3F922-390F-4AFF-9A92-5B98CFEDB5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1637529"/>
              </p:ext>
            </p:extLst>
          </p:nvPr>
        </p:nvGraphicFramePr>
        <p:xfrm>
          <a:off x="4383088" y="1040020"/>
          <a:ext cx="2116137" cy="1785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22" name="Prism Project" r:id="rId5" imgW="3470040" imgH="2931840" progId="Prism5.Document">
                  <p:embed/>
                </p:oleObj>
              </mc:Choice>
              <mc:Fallback>
                <p:oleObj name="Prism Project" r:id="rId5" imgW="3470040" imgH="293184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83088" y="1040020"/>
                        <a:ext cx="2116137" cy="1785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1FA1D4F7-A62A-439F-807C-48C21A6C76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2583932"/>
              </p:ext>
            </p:extLst>
          </p:nvPr>
        </p:nvGraphicFramePr>
        <p:xfrm>
          <a:off x="2211388" y="1022558"/>
          <a:ext cx="2216150" cy="1787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23" name="Prism Project" r:id="rId7" imgW="3634560" imgH="2931840" progId="Prism5.Document">
                  <p:embed/>
                </p:oleObj>
              </mc:Choice>
              <mc:Fallback>
                <p:oleObj name="Prism Project" r:id="rId7" imgW="3634560" imgH="293184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11388" y="1022558"/>
                        <a:ext cx="2216150" cy="1787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EDA965AB-8B41-4075-9D03-C5F47099AA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8272179"/>
              </p:ext>
            </p:extLst>
          </p:nvPr>
        </p:nvGraphicFramePr>
        <p:xfrm>
          <a:off x="-4763" y="1049545"/>
          <a:ext cx="2370138" cy="179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24" name="Prism Project" r:id="rId9" imgW="3506400" imgH="2653200" progId="Prism5.Document">
                  <p:embed/>
                </p:oleObj>
              </mc:Choice>
              <mc:Fallback>
                <p:oleObj name="Prism Project" r:id="rId9" imgW="3506400" imgH="26532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-4763" y="1049545"/>
                        <a:ext cx="2370138" cy="179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74">
            <a:extLst>
              <a:ext uri="{FF2B5EF4-FFF2-40B4-BE49-F238E27FC236}">
                <a16:creationId xmlns:a16="http://schemas.microsoft.com/office/drawing/2014/main" id="{A30BD5AB-0D28-41B4-B0FE-2475DE1AE0DE}"/>
              </a:ext>
            </a:extLst>
          </p:cNvPr>
          <p:cNvSpPr txBox="1"/>
          <p:nvPr/>
        </p:nvSpPr>
        <p:spPr>
          <a:xfrm>
            <a:off x="91440" y="5156619"/>
            <a:ext cx="2199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CC0E6EA4-A717-4FB4-A06A-8CEEDF700199}"/>
              </a:ext>
            </a:extLst>
          </p:cNvPr>
          <p:cNvGrpSpPr/>
          <p:nvPr/>
        </p:nvGrpSpPr>
        <p:grpSpPr>
          <a:xfrm>
            <a:off x="143412" y="5395162"/>
            <a:ext cx="6656530" cy="3796237"/>
            <a:chOff x="94507" y="3345215"/>
            <a:chExt cx="6656530" cy="3796237"/>
          </a:xfrm>
        </p:grpSpPr>
        <p:sp>
          <p:nvSpPr>
            <p:cNvPr id="24" name="TextBox 51">
              <a:extLst>
                <a:ext uri="{FF2B5EF4-FFF2-40B4-BE49-F238E27FC236}">
                  <a16:creationId xmlns:a16="http://schemas.microsoft.com/office/drawing/2014/main" id="{6C1B4E52-F20C-4106-9417-5687EEAD2F03}"/>
                </a:ext>
              </a:extLst>
            </p:cNvPr>
            <p:cNvSpPr txBox="1"/>
            <p:nvPr/>
          </p:nvSpPr>
          <p:spPr>
            <a:xfrm>
              <a:off x="5694849" y="4925458"/>
              <a:ext cx="1044965" cy="1107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</a:p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it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H3: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15K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ctin:43K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53">
              <a:extLst>
                <a:ext uri="{FF2B5EF4-FFF2-40B4-BE49-F238E27FC236}">
                  <a16:creationId xmlns:a16="http://schemas.microsoft.com/office/drawing/2014/main" id="{29D689D5-E1D3-43B3-8B2F-8F24819C70B3}"/>
                </a:ext>
              </a:extLst>
            </p:cNvPr>
            <p:cNvSpPr txBox="1"/>
            <p:nvPr/>
          </p:nvSpPr>
          <p:spPr>
            <a:xfrm>
              <a:off x="113184" y="5086988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ung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54">
              <a:extLst>
                <a:ext uri="{FF2B5EF4-FFF2-40B4-BE49-F238E27FC236}">
                  <a16:creationId xmlns:a16="http://schemas.microsoft.com/office/drawing/2014/main" id="{425FF194-62F7-4E31-B753-1B418166E5AF}"/>
                </a:ext>
              </a:extLst>
            </p:cNvPr>
            <p:cNvSpPr txBox="1"/>
            <p:nvPr/>
          </p:nvSpPr>
          <p:spPr>
            <a:xfrm>
              <a:off x="94507" y="6376957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51">
              <a:extLst>
                <a:ext uri="{FF2B5EF4-FFF2-40B4-BE49-F238E27FC236}">
                  <a16:creationId xmlns:a16="http://schemas.microsoft.com/office/drawing/2014/main" id="{27B4BC8B-3D9C-4145-97EE-5B806D90266D}"/>
                </a:ext>
              </a:extLst>
            </p:cNvPr>
            <p:cNvSpPr txBox="1"/>
            <p:nvPr/>
          </p:nvSpPr>
          <p:spPr>
            <a:xfrm>
              <a:off x="5706072" y="6033455"/>
              <a:ext cx="1044965" cy="1107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</a:p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it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H3: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15K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ctin:43K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50">
              <a:extLst>
                <a:ext uri="{FF2B5EF4-FFF2-40B4-BE49-F238E27FC236}">
                  <a16:creationId xmlns:a16="http://schemas.microsoft.com/office/drawing/2014/main" id="{192A3857-CA5F-43AC-9441-852CB7BE62F0}"/>
                </a:ext>
              </a:extLst>
            </p:cNvPr>
            <p:cNvSpPr txBox="1"/>
            <p:nvPr/>
          </p:nvSpPr>
          <p:spPr>
            <a:xfrm>
              <a:off x="568449" y="3345215"/>
              <a:ext cx="564888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Flox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6h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 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F4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6h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 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Flox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12h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F4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12h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Flox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F4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CAA26ED7-CCAF-4A74-9E5C-78DAB29312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68312" y="4943493"/>
              <a:ext cx="4937760" cy="408779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A2EE2C16-20AE-426E-99E7-6A9CCDB1AAF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768313" y="5403886"/>
              <a:ext cx="4937759" cy="43309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5B6B8C6F-AA66-48D7-9B85-7CE6A7F417A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57089" y="6069061"/>
              <a:ext cx="4937760" cy="408779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4A5F123D-4BE0-47D5-A0C2-7889C020A90D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68313" y="6526183"/>
              <a:ext cx="4937759" cy="408779"/>
            </a:xfrm>
            <a:prstGeom prst="rect">
              <a:avLst/>
            </a:prstGeom>
          </p:spPr>
        </p:pic>
      </p:grpSp>
      <p:sp>
        <p:nvSpPr>
          <p:cNvPr id="20" name="矩形 19">
            <a:extLst>
              <a:ext uri="{FF2B5EF4-FFF2-40B4-BE49-F238E27FC236}">
                <a16:creationId xmlns:a16="http://schemas.microsoft.com/office/drawing/2014/main" id="{43466C7D-5FE1-4500-B72B-1CE0D0E18352}"/>
              </a:ext>
            </a:extLst>
          </p:cNvPr>
          <p:cNvSpPr/>
          <p:nvPr/>
        </p:nvSpPr>
        <p:spPr>
          <a:xfrm>
            <a:off x="3788885" y="5097567"/>
            <a:ext cx="283763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1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inogen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13" descr="H:\4.IF.12.2019\78LM16 Tsung - Julie\after talking with HAI\liver\LV4_blue-nuclei_red-fibrinogen_green-CD41_white-actin_20x2z_3x3 400X400 25UM BAR.tif">
            <a:extLst>
              <a:ext uri="{FF2B5EF4-FFF2-40B4-BE49-F238E27FC236}">
                <a16:creationId xmlns:a16="http://schemas.microsoft.com/office/drawing/2014/main" id="{D04DBC93-5E47-438A-936F-A234E21A084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7594" y="3261765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14" descr="H:\4.IF.12.2019\78LM16 Tsung - Julie\after talking with HAI\liver\LV2_blue-nuclei_red-fibrinogen_green-CD41_white-actin_20x2z_3x3 400X400 25UM BAR.tif">
            <a:extLst>
              <a:ext uri="{FF2B5EF4-FFF2-40B4-BE49-F238E27FC236}">
                <a16:creationId xmlns:a16="http://schemas.microsoft.com/office/drawing/2014/main" id="{CCAA6AA6-847A-4114-9231-E98D26139B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183" y="3261765"/>
            <a:ext cx="18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62CBC6B7-C255-4098-A371-DEDA3C5951B8}"/>
              </a:ext>
            </a:extLst>
          </p:cNvPr>
          <p:cNvCxnSpPr/>
          <p:nvPr/>
        </p:nvCxnSpPr>
        <p:spPr>
          <a:xfrm flipH="1">
            <a:off x="4058759" y="4485190"/>
            <a:ext cx="263327" cy="0"/>
          </a:xfrm>
          <a:prstGeom prst="straightConnector1">
            <a:avLst/>
          </a:prstGeom>
          <a:ln w="28575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2C2E0BC4-5018-4F47-B570-7F707C1675C5}"/>
              </a:ext>
            </a:extLst>
          </p:cNvPr>
          <p:cNvCxnSpPr/>
          <p:nvPr/>
        </p:nvCxnSpPr>
        <p:spPr>
          <a:xfrm flipH="1">
            <a:off x="3998576" y="4002790"/>
            <a:ext cx="263327" cy="0"/>
          </a:xfrm>
          <a:prstGeom prst="straightConnector1">
            <a:avLst/>
          </a:prstGeom>
          <a:ln w="28575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矩形 28">
            <a:extLst>
              <a:ext uri="{FF2B5EF4-FFF2-40B4-BE49-F238E27FC236}">
                <a16:creationId xmlns:a16="http://schemas.microsoft.com/office/drawing/2014/main" id="{939092D7-73AD-45DC-A2F3-4446337E096A}"/>
              </a:ext>
            </a:extLst>
          </p:cNvPr>
          <p:cNvSpPr/>
          <p:nvPr/>
        </p:nvSpPr>
        <p:spPr>
          <a:xfrm>
            <a:off x="4655450" y="3194859"/>
            <a:ext cx="119936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F4 KO 6h</a:t>
            </a: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3300100E-0827-4ACB-97AA-02DFF67DE4DD}"/>
              </a:ext>
            </a:extLst>
          </p:cNvPr>
          <p:cNvSpPr/>
          <p:nvPr/>
        </p:nvSpPr>
        <p:spPr>
          <a:xfrm>
            <a:off x="2823742" y="3199371"/>
            <a:ext cx="156485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: FLOX 6h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74">
            <a:extLst>
              <a:ext uri="{FF2B5EF4-FFF2-40B4-BE49-F238E27FC236}">
                <a16:creationId xmlns:a16="http://schemas.microsoft.com/office/drawing/2014/main" id="{76AA8639-175D-4A1D-8871-B047C97FB80E}"/>
              </a:ext>
            </a:extLst>
          </p:cNvPr>
          <p:cNvSpPr txBox="1"/>
          <p:nvPr/>
        </p:nvSpPr>
        <p:spPr>
          <a:xfrm>
            <a:off x="2488000" y="2804338"/>
            <a:ext cx="251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TextBox 74">
            <a:extLst>
              <a:ext uri="{FF2B5EF4-FFF2-40B4-BE49-F238E27FC236}">
                <a16:creationId xmlns:a16="http://schemas.microsoft.com/office/drawing/2014/main" id="{9FA1520E-0E11-4EA3-8CA2-D85A66D1A8FD}"/>
              </a:ext>
            </a:extLst>
          </p:cNvPr>
          <p:cNvSpPr txBox="1"/>
          <p:nvPr/>
        </p:nvSpPr>
        <p:spPr>
          <a:xfrm>
            <a:off x="63837" y="2843461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5" name="对象 34">
            <a:extLst>
              <a:ext uri="{FF2B5EF4-FFF2-40B4-BE49-F238E27FC236}">
                <a16:creationId xmlns:a16="http://schemas.microsoft.com/office/drawing/2014/main" id="{DA0135C5-DCB6-4E2B-9049-C1D96944F6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3336244"/>
              </p:ext>
            </p:extLst>
          </p:nvPr>
        </p:nvGraphicFramePr>
        <p:xfrm>
          <a:off x="216726" y="3260898"/>
          <a:ext cx="2462226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25" name="Prism Project" r:id="rId19" imgW="3672000" imgH="2952000" progId="Prism5.Document">
                  <p:embed/>
                </p:oleObj>
              </mc:Choice>
              <mc:Fallback>
                <p:oleObj name="Prism Project" r:id="rId19" imgW="3672000" imgH="2952000" progId="Prism5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F12AA70D-D855-4EF6-B4F2-D711B218CD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16726" y="3260898"/>
                        <a:ext cx="2462226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图片 2">
            <a:extLst>
              <a:ext uri="{FF2B5EF4-FFF2-40B4-BE49-F238E27FC236}">
                <a16:creationId xmlns:a16="http://schemas.microsoft.com/office/drawing/2014/main" id="{E2A164FC-7DFC-41EE-8FC5-20BD8A1301D1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22969" y="5876255"/>
            <a:ext cx="4937760" cy="48274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B036D84-9CD6-4A88-A064-A5410BEAC38A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817218" y="6395132"/>
            <a:ext cx="4937760" cy="488889"/>
          </a:xfrm>
          <a:prstGeom prst="rect">
            <a:avLst/>
          </a:prstGeom>
        </p:spPr>
      </p:pic>
      <p:sp>
        <p:nvSpPr>
          <p:cNvPr id="36" name="TextBox 51">
            <a:extLst>
              <a:ext uri="{FF2B5EF4-FFF2-40B4-BE49-F238E27FC236}">
                <a16:creationId xmlns:a16="http://schemas.microsoft.com/office/drawing/2014/main" id="{CB243060-42BF-4C75-9D6B-8B34B890E7BC}"/>
              </a:ext>
            </a:extLst>
          </p:cNvPr>
          <p:cNvSpPr txBox="1"/>
          <p:nvPr/>
        </p:nvSpPr>
        <p:spPr>
          <a:xfrm>
            <a:off x="5737129" y="5855593"/>
            <a:ext cx="1044965" cy="1107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</a:p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i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3: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Actin:43KD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53">
            <a:extLst>
              <a:ext uri="{FF2B5EF4-FFF2-40B4-BE49-F238E27FC236}">
                <a16:creationId xmlns:a16="http://schemas.microsoft.com/office/drawing/2014/main" id="{AEA9B890-7072-4088-A5D3-4E8D446EA666}"/>
              </a:ext>
            </a:extLst>
          </p:cNvPr>
          <p:cNvSpPr txBox="1"/>
          <p:nvPr/>
        </p:nvSpPr>
        <p:spPr>
          <a:xfrm>
            <a:off x="175343" y="6176151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17284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91440" y="4269017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DDC3869B-2626-4651-BF3E-5A1A42D40540}"/>
              </a:ext>
            </a:extLst>
          </p:cNvPr>
          <p:cNvSpPr/>
          <p:nvPr/>
        </p:nvSpPr>
        <p:spPr>
          <a:xfrm>
            <a:off x="4617729" y="1355126"/>
            <a:ext cx="12218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F4 KO 6h</a:t>
            </a:r>
          </a:p>
        </p:txBody>
      </p:sp>
      <p:sp>
        <p:nvSpPr>
          <p:cNvPr id="96" name="TextBox 74">
            <a:extLst>
              <a:ext uri="{FF2B5EF4-FFF2-40B4-BE49-F238E27FC236}">
                <a16:creationId xmlns:a16="http://schemas.microsoft.com/office/drawing/2014/main" id="{0E31F53D-1A27-4022-9DFE-511E588B56E1}"/>
              </a:ext>
            </a:extLst>
          </p:cNvPr>
          <p:cNvSpPr txBox="1"/>
          <p:nvPr/>
        </p:nvSpPr>
        <p:spPr>
          <a:xfrm>
            <a:off x="91440" y="2463799"/>
            <a:ext cx="251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2" name="TextBox 74">
            <a:extLst>
              <a:ext uri="{FF2B5EF4-FFF2-40B4-BE49-F238E27FC236}">
                <a16:creationId xmlns:a16="http://schemas.microsoft.com/office/drawing/2014/main" id="{ECEA7AD7-392B-489B-81C2-3BB3445B6D57}"/>
              </a:ext>
            </a:extLst>
          </p:cNvPr>
          <p:cNvSpPr txBox="1"/>
          <p:nvPr/>
        </p:nvSpPr>
        <p:spPr>
          <a:xfrm>
            <a:off x="91440" y="245657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6718A29-0E4A-4E0A-811C-8ACE854448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6257" y="213198"/>
            <a:ext cx="1682836" cy="939848"/>
          </a:xfrm>
          <a:prstGeom prst="rect">
            <a:avLst/>
          </a:prstGeom>
        </p:spPr>
      </p:pic>
      <p:sp>
        <p:nvSpPr>
          <p:cNvPr id="19" name="TextBox 74">
            <a:extLst>
              <a:ext uri="{FF2B5EF4-FFF2-40B4-BE49-F238E27FC236}">
                <a16:creationId xmlns:a16="http://schemas.microsoft.com/office/drawing/2014/main" id="{90890C4A-877B-469C-9931-78F54182161B}"/>
              </a:ext>
            </a:extLst>
          </p:cNvPr>
          <p:cNvSpPr txBox="1"/>
          <p:nvPr/>
        </p:nvSpPr>
        <p:spPr>
          <a:xfrm>
            <a:off x="2655736" y="4189505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74">
            <a:extLst>
              <a:ext uri="{FF2B5EF4-FFF2-40B4-BE49-F238E27FC236}">
                <a16:creationId xmlns:a16="http://schemas.microsoft.com/office/drawing/2014/main" id="{83548471-9F1C-4981-9504-580977CFA89C}"/>
              </a:ext>
            </a:extLst>
          </p:cNvPr>
          <p:cNvSpPr txBox="1"/>
          <p:nvPr/>
        </p:nvSpPr>
        <p:spPr>
          <a:xfrm>
            <a:off x="91440" y="6229518"/>
            <a:ext cx="188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195FB1E8-A57E-4285-B816-5B84C4B129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218718"/>
              </p:ext>
            </p:extLst>
          </p:nvPr>
        </p:nvGraphicFramePr>
        <p:xfrm>
          <a:off x="4617729" y="4544951"/>
          <a:ext cx="2286000" cy="17191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39" name="Prism Project" r:id="rId5" imgW="3492000" imgH="2628000" progId="Prism5.Document">
                  <p:embed/>
                </p:oleObj>
              </mc:Choice>
              <mc:Fallback>
                <p:oleObj name="Prism Project" r:id="rId5" imgW="3492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17729" y="4544951"/>
                        <a:ext cx="2286000" cy="17191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B0FF38AA-BF78-4F10-8C27-3CC3398B0E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9999343"/>
              </p:ext>
            </p:extLst>
          </p:nvPr>
        </p:nvGraphicFramePr>
        <p:xfrm>
          <a:off x="160338" y="2252662"/>
          <a:ext cx="2431908" cy="20299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0" name="Prism Project" r:id="rId7" imgW="3492000" imgH="2916000" progId="Prism5.Document">
                  <p:embed/>
                </p:oleObj>
              </mc:Choice>
              <mc:Fallback>
                <p:oleObj name="Prism Project" r:id="rId7" imgW="3492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60338" y="2252662"/>
                        <a:ext cx="2431908" cy="20299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0D8391E8-DD3C-4B8D-B732-C5DF99CBD7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1945019"/>
              </p:ext>
            </p:extLst>
          </p:nvPr>
        </p:nvGraphicFramePr>
        <p:xfrm>
          <a:off x="3132138" y="2159000"/>
          <a:ext cx="2260600" cy="2051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1" name="Prism Project" r:id="rId9" imgW="3132000" imgH="2844000" progId="Prism5.Document">
                  <p:embed/>
                </p:oleObj>
              </mc:Choice>
              <mc:Fallback>
                <p:oleObj name="Prism Project" r:id="rId9" imgW="3132000" imgH="284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132138" y="2159000"/>
                        <a:ext cx="2260600" cy="2051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05537E86-B469-48D4-91D0-6827D3DCAE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1011634"/>
              </p:ext>
            </p:extLst>
          </p:nvPr>
        </p:nvGraphicFramePr>
        <p:xfrm>
          <a:off x="341313" y="4148138"/>
          <a:ext cx="2286000" cy="21285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2" name="Prism Project" r:id="rId11" imgW="3132000" imgH="2916000" progId="Prism5.Document">
                  <p:embed/>
                </p:oleObj>
              </mc:Choice>
              <mc:Fallback>
                <p:oleObj name="Prism Project" r:id="rId11" imgW="3132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1313" y="4148138"/>
                        <a:ext cx="2286000" cy="21285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45E5D27C-EF2D-459D-9BBC-86F613D03D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9517974"/>
              </p:ext>
            </p:extLst>
          </p:nvPr>
        </p:nvGraphicFramePr>
        <p:xfrm>
          <a:off x="385763" y="101600"/>
          <a:ext cx="2259012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3" name="Prism Project" r:id="rId13" imgW="3132000" imgH="2916000" progId="Prism5.Document">
                  <p:embed/>
                </p:oleObj>
              </mc:Choice>
              <mc:Fallback>
                <p:oleObj name="Prism Project" r:id="rId13" imgW="3132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5763" y="101600"/>
                        <a:ext cx="2259012" cy="2101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112ED7CF-C466-458A-9CDB-D1481C41ED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6220553"/>
              </p:ext>
            </p:extLst>
          </p:nvPr>
        </p:nvGraphicFramePr>
        <p:xfrm>
          <a:off x="3055938" y="150813"/>
          <a:ext cx="2286000" cy="2079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4" name="Prism Project" r:id="rId15" imgW="3204000" imgH="2916000" progId="Prism5.Document">
                  <p:embed/>
                </p:oleObj>
              </mc:Choice>
              <mc:Fallback>
                <p:oleObj name="Prism Project" r:id="rId15" imgW="3204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055938" y="150813"/>
                        <a:ext cx="2286000" cy="2079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95719270-3671-474A-A010-C2CAB315C8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1734489"/>
              </p:ext>
            </p:extLst>
          </p:nvPr>
        </p:nvGraphicFramePr>
        <p:xfrm>
          <a:off x="2319337" y="6353175"/>
          <a:ext cx="2286000" cy="1863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5" name="Prism Project" r:id="rId17" imgW="3597840" imgH="2931840" progId="Prism5.Document">
                  <p:embed/>
                </p:oleObj>
              </mc:Choice>
              <mc:Fallback>
                <p:oleObj name="Prism Project" r:id="rId17" imgW="3597840" imgH="293184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319337" y="6353175"/>
                        <a:ext cx="2286000" cy="1863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E3CB48FE-CD35-4BDA-8319-52873E33EE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544067"/>
              </p:ext>
            </p:extLst>
          </p:nvPr>
        </p:nvGraphicFramePr>
        <p:xfrm>
          <a:off x="4505325" y="6323013"/>
          <a:ext cx="2286000" cy="18591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6" name="Prism Project" r:id="rId19" imgW="3470040" imgH="2822400" progId="Prism5.Document">
                  <p:embed/>
                </p:oleObj>
              </mc:Choice>
              <mc:Fallback>
                <p:oleObj name="Prism Project" r:id="rId19" imgW="3470040" imgH="2822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505325" y="6323013"/>
                        <a:ext cx="2286000" cy="18591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145B785A-55DA-4D59-9C62-3347B5AEA2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5374111"/>
              </p:ext>
            </p:extLst>
          </p:nvPr>
        </p:nvGraphicFramePr>
        <p:xfrm>
          <a:off x="169863" y="6256338"/>
          <a:ext cx="2286000" cy="1906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7" name="Prism Project" r:id="rId21" imgW="3492000" imgH="2916000" progId="Prism5.Document">
                  <p:embed/>
                </p:oleObj>
              </mc:Choice>
              <mc:Fallback>
                <p:oleObj name="Prism Project" r:id="rId21" imgW="3492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69863" y="6256338"/>
                        <a:ext cx="2286000" cy="1906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33258291-C150-49E1-ADA0-5B0CCACF64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5467943"/>
              </p:ext>
            </p:extLst>
          </p:nvPr>
        </p:nvGraphicFramePr>
        <p:xfrm>
          <a:off x="2334481" y="4303260"/>
          <a:ext cx="2501621" cy="2011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8" name="Prism Project" r:id="rId23" imgW="3672000" imgH="2952000" progId="Prism5.Document">
                  <p:embed/>
                </p:oleObj>
              </mc:Choice>
              <mc:Fallback>
                <p:oleObj name="Prism Project" r:id="rId23" imgW="3672000" imgH="295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334481" y="4303260"/>
                        <a:ext cx="2501621" cy="2011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74">
            <a:extLst>
              <a:ext uri="{FF2B5EF4-FFF2-40B4-BE49-F238E27FC236}">
                <a16:creationId xmlns:a16="http://schemas.microsoft.com/office/drawing/2014/main" id="{F286E80A-314E-4E63-90B2-143188CD1064}"/>
              </a:ext>
            </a:extLst>
          </p:cNvPr>
          <p:cNvSpPr txBox="1"/>
          <p:nvPr/>
        </p:nvSpPr>
        <p:spPr>
          <a:xfrm>
            <a:off x="4669034" y="4195077"/>
            <a:ext cx="205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192191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725</TotalTime>
  <Words>1711</Words>
  <Application>Microsoft Office PowerPoint</Application>
  <PresentationFormat>全屏显示(4:3)</PresentationFormat>
  <Paragraphs>232</Paragraphs>
  <Slides>9</Slides>
  <Notes>9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Arial</vt:lpstr>
      <vt:lpstr>Calibri</vt:lpstr>
      <vt:lpstr>Times New Roman</vt:lpstr>
      <vt:lpstr>Office Theme</vt:lpstr>
      <vt:lpstr>Prism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UP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Goswami</dc:creator>
  <cp:lastModifiedBy>Zhang, Hongji</cp:lastModifiedBy>
  <cp:revision>590</cp:revision>
  <dcterms:created xsi:type="dcterms:W3CDTF">2016-10-31T16:38:30Z</dcterms:created>
  <dcterms:modified xsi:type="dcterms:W3CDTF">2020-04-24T06:55:13Z</dcterms:modified>
</cp:coreProperties>
</file>